
<file path=[Content_Types].xml><?xml version="1.0" encoding="utf-8"?>
<Types xmlns="http://schemas.openxmlformats.org/package/2006/content-types">
  <Default Extension="tmp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BDD0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59" d="100"/>
          <a:sy n="59" d="100"/>
        </p:scale>
        <p:origin x="63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MILA OSPINA AYALA" userId="78f2fe8b-a352-4d21-8a73-8c582c191c8b" providerId="ADAL" clId="{60061412-3791-4796-9D2B-5B9AAF64AB0F}"/>
    <pc:docChg chg="custSel modSld">
      <pc:chgData name="CAMILA OSPINA AYALA" userId="78f2fe8b-a352-4d21-8a73-8c582c191c8b" providerId="ADAL" clId="{60061412-3791-4796-9D2B-5B9AAF64AB0F}" dt="2022-02-25T11:23:25.067" v="10" actId="167"/>
      <pc:docMkLst>
        <pc:docMk/>
      </pc:docMkLst>
      <pc:sldChg chg="addSp delSp modSp mod">
        <pc:chgData name="CAMILA OSPINA AYALA" userId="78f2fe8b-a352-4d21-8a73-8c582c191c8b" providerId="ADAL" clId="{60061412-3791-4796-9D2B-5B9AAF64AB0F}" dt="2022-02-25T11:23:25.067" v="10" actId="167"/>
        <pc:sldMkLst>
          <pc:docMk/>
          <pc:sldMk cId="3513509246" sldId="256"/>
        </pc:sldMkLst>
        <pc:picChg chg="del">
          <ac:chgData name="CAMILA OSPINA AYALA" userId="78f2fe8b-a352-4d21-8a73-8c582c191c8b" providerId="ADAL" clId="{60061412-3791-4796-9D2B-5B9AAF64AB0F}" dt="2022-02-25T11:22:36.819" v="0" actId="478"/>
          <ac:picMkLst>
            <pc:docMk/>
            <pc:sldMk cId="3513509246" sldId="256"/>
            <ac:picMk id="4" creationId="{E0B5F59A-EC54-4B52-9493-BE67EA709632}"/>
          </ac:picMkLst>
        </pc:picChg>
        <pc:picChg chg="add mod ord">
          <ac:chgData name="CAMILA OSPINA AYALA" userId="78f2fe8b-a352-4d21-8a73-8c582c191c8b" providerId="ADAL" clId="{60061412-3791-4796-9D2B-5B9AAF64AB0F}" dt="2022-02-25T11:23:25.067" v="10" actId="167"/>
          <ac:picMkLst>
            <pc:docMk/>
            <pc:sldMk cId="3513509246" sldId="256"/>
            <ac:picMk id="5" creationId="{9CD7E43F-978E-49CB-B105-04AED7AC3AD5}"/>
          </ac:picMkLst>
        </pc:picChg>
      </pc:sldChg>
    </pc:docChg>
  </pc:docChgLst>
  <pc:docChgLst>
    <pc:chgData name="CAMILA OSPINA AYALA" userId="78f2fe8b-a352-4d21-8a73-8c582c191c8b" providerId="ADAL" clId="{DEA165F4-38F5-4709-B229-2566A93E9A4E}"/>
    <pc:docChg chg="custSel modSld">
      <pc:chgData name="CAMILA OSPINA AYALA" userId="78f2fe8b-a352-4d21-8a73-8c582c191c8b" providerId="ADAL" clId="{DEA165F4-38F5-4709-B229-2566A93E9A4E}" dt="2022-02-24T21:49:06.229" v="26" actId="14100"/>
      <pc:docMkLst>
        <pc:docMk/>
      </pc:docMkLst>
      <pc:sldChg chg="addSp delSp modSp mod">
        <pc:chgData name="CAMILA OSPINA AYALA" userId="78f2fe8b-a352-4d21-8a73-8c582c191c8b" providerId="ADAL" clId="{DEA165F4-38F5-4709-B229-2566A93E9A4E}" dt="2022-02-24T21:49:06.229" v="26" actId="14100"/>
        <pc:sldMkLst>
          <pc:docMk/>
          <pc:sldMk cId="3513509246" sldId="256"/>
        </pc:sldMkLst>
        <pc:picChg chg="add mod">
          <ac:chgData name="CAMILA OSPINA AYALA" userId="78f2fe8b-a352-4d21-8a73-8c582c191c8b" providerId="ADAL" clId="{DEA165F4-38F5-4709-B229-2566A93E9A4E}" dt="2022-02-24T21:49:06.229" v="26" actId="14100"/>
          <ac:picMkLst>
            <pc:docMk/>
            <pc:sldMk cId="3513509246" sldId="256"/>
            <ac:picMk id="4" creationId="{E0B5F59A-EC54-4B52-9493-BE67EA709632}"/>
          </ac:picMkLst>
        </pc:picChg>
        <pc:picChg chg="del">
          <ac:chgData name="CAMILA OSPINA AYALA" userId="78f2fe8b-a352-4d21-8a73-8c582c191c8b" providerId="ADAL" clId="{DEA165F4-38F5-4709-B229-2566A93E9A4E}" dt="2022-02-24T21:41:20.925" v="0" actId="478"/>
          <ac:picMkLst>
            <pc:docMk/>
            <pc:sldMk cId="3513509246" sldId="256"/>
            <ac:picMk id="4" creationId="{E927BDED-F7F8-4118-95A6-5DD1716F8A88}"/>
          </ac:picMkLst>
        </pc:picChg>
        <pc:picChg chg="add del mod">
          <ac:chgData name="CAMILA OSPINA AYALA" userId="78f2fe8b-a352-4d21-8a73-8c582c191c8b" providerId="ADAL" clId="{DEA165F4-38F5-4709-B229-2566A93E9A4E}" dt="2022-02-24T21:41:42.350" v="4" actId="478"/>
          <ac:picMkLst>
            <pc:docMk/>
            <pc:sldMk cId="3513509246" sldId="256"/>
            <ac:picMk id="5" creationId="{A6F3B7B6-7090-4BD1-B720-F09D6EE61641}"/>
          </ac:picMkLst>
        </pc:picChg>
        <pc:picChg chg="add del mod">
          <ac:chgData name="CAMILA OSPINA AYALA" userId="78f2fe8b-a352-4d21-8a73-8c582c191c8b" providerId="ADAL" clId="{DEA165F4-38F5-4709-B229-2566A93E9A4E}" dt="2022-02-24T21:48:21.669" v="17" actId="478"/>
          <ac:picMkLst>
            <pc:docMk/>
            <pc:sldMk cId="3513509246" sldId="256"/>
            <ac:picMk id="7" creationId="{732818A7-685B-4998-A74C-A345B3A68B28}"/>
          </ac:picMkLst>
        </pc:picChg>
      </pc:sldChg>
    </pc:docChg>
  </pc:docChgLst>
  <pc:docChgLst>
    <pc:chgData name="CAMILA OSPINA AYALA" userId="78f2fe8b-a352-4d21-8a73-8c582c191c8b" providerId="ADAL" clId="{119E72F5-B702-4FC4-BA70-ABCFE9C2451C}"/>
    <pc:docChg chg="undo custSel modSld">
      <pc:chgData name="CAMILA OSPINA AYALA" userId="78f2fe8b-a352-4d21-8a73-8c582c191c8b" providerId="ADAL" clId="{119E72F5-B702-4FC4-BA70-ABCFE9C2451C}" dt="2022-03-02T11:42:08.833" v="239" actId="2711"/>
      <pc:docMkLst>
        <pc:docMk/>
      </pc:docMkLst>
      <pc:sldChg chg="addSp delSp modSp mod">
        <pc:chgData name="CAMILA OSPINA AYALA" userId="78f2fe8b-a352-4d21-8a73-8c582c191c8b" providerId="ADAL" clId="{119E72F5-B702-4FC4-BA70-ABCFE9C2451C}" dt="2022-03-02T11:42:08.833" v="239" actId="2711"/>
        <pc:sldMkLst>
          <pc:docMk/>
          <pc:sldMk cId="3513509246" sldId="256"/>
        </pc:sldMkLst>
        <pc:spChg chg="mod">
          <ac:chgData name="CAMILA OSPINA AYALA" userId="78f2fe8b-a352-4d21-8a73-8c582c191c8b" providerId="ADAL" clId="{119E72F5-B702-4FC4-BA70-ABCFE9C2451C}" dt="2022-03-02T11:41:56.189" v="237" actId="2711"/>
          <ac:spMkLst>
            <pc:docMk/>
            <pc:sldMk cId="3513509246" sldId="256"/>
            <ac:spMk id="14" creationId="{559545BB-4BA5-4679-B338-FBC782E75B16}"/>
          </ac:spMkLst>
        </pc:spChg>
        <pc:spChg chg="mod topLvl">
          <ac:chgData name="CAMILA OSPINA AYALA" userId="78f2fe8b-a352-4d21-8a73-8c582c191c8b" providerId="ADAL" clId="{119E72F5-B702-4FC4-BA70-ABCFE9C2451C}" dt="2022-03-02T11:41:19.168" v="232" actId="571"/>
          <ac:spMkLst>
            <pc:docMk/>
            <pc:sldMk cId="3513509246" sldId="256"/>
            <ac:spMk id="19" creationId="{AC4C3DC5-C950-4469-B152-4E43DE1B5036}"/>
          </ac:spMkLst>
        </pc:spChg>
        <pc:spChg chg="mod topLvl">
          <ac:chgData name="CAMILA OSPINA AYALA" userId="78f2fe8b-a352-4d21-8a73-8c582c191c8b" providerId="ADAL" clId="{119E72F5-B702-4FC4-BA70-ABCFE9C2451C}" dt="2022-03-02T11:41:19.168" v="232" actId="571"/>
          <ac:spMkLst>
            <pc:docMk/>
            <pc:sldMk cId="3513509246" sldId="256"/>
            <ac:spMk id="21" creationId="{1CA3E8AA-CACE-4939-89EE-2E2C569FA7D2}"/>
          </ac:spMkLst>
        </pc:spChg>
        <pc:spChg chg="mod topLvl">
          <ac:chgData name="CAMILA OSPINA AYALA" userId="78f2fe8b-a352-4d21-8a73-8c582c191c8b" providerId="ADAL" clId="{119E72F5-B702-4FC4-BA70-ABCFE9C2451C}" dt="2022-03-02T11:41:19.168" v="232" actId="571"/>
          <ac:spMkLst>
            <pc:docMk/>
            <pc:sldMk cId="3513509246" sldId="256"/>
            <ac:spMk id="23" creationId="{2223FC15-4D9E-4B6E-8A58-F6F5B19D2659}"/>
          </ac:spMkLst>
        </pc:spChg>
        <pc:spChg chg="mod topLvl">
          <ac:chgData name="CAMILA OSPINA AYALA" userId="78f2fe8b-a352-4d21-8a73-8c582c191c8b" providerId="ADAL" clId="{119E72F5-B702-4FC4-BA70-ABCFE9C2451C}" dt="2022-03-02T11:41:19.168" v="232" actId="571"/>
          <ac:spMkLst>
            <pc:docMk/>
            <pc:sldMk cId="3513509246" sldId="256"/>
            <ac:spMk id="25" creationId="{599088B4-5A7A-4909-B659-A569413595EE}"/>
          </ac:spMkLst>
        </pc:spChg>
        <pc:spChg chg="mod topLvl">
          <ac:chgData name="CAMILA OSPINA AYALA" userId="78f2fe8b-a352-4d21-8a73-8c582c191c8b" providerId="ADAL" clId="{119E72F5-B702-4FC4-BA70-ABCFE9C2451C}" dt="2022-03-02T11:41:19.168" v="232" actId="571"/>
          <ac:spMkLst>
            <pc:docMk/>
            <pc:sldMk cId="3513509246" sldId="256"/>
            <ac:spMk id="26" creationId="{000E1D5E-750D-4A86-887D-B8AE804C8B3B}"/>
          </ac:spMkLst>
        </pc:spChg>
        <pc:spChg chg="mod topLvl">
          <ac:chgData name="CAMILA OSPINA AYALA" userId="78f2fe8b-a352-4d21-8a73-8c582c191c8b" providerId="ADAL" clId="{119E72F5-B702-4FC4-BA70-ABCFE9C2451C}" dt="2022-03-02T11:41:19.168" v="232" actId="571"/>
          <ac:spMkLst>
            <pc:docMk/>
            <pc:sldMk cId="3513509246" sldId="256"/>
            <ac:spMk id="27" creationId="{EDE3F7CC-9264-4DB8-90A9-8EF5F9D9F236}"/>
          </ac:spMkLst>
        </pc:spChg>
        <pc:spChg chg="mod topLvl">
          <ac:chgData name="CAMILA OSPINA AYALA" userId="78f2fe8b-a352-4d21-8a73-8c582c191c8b" providerId="ADAL" clId="{119E72F5-B702-4FC4-BA70-ABCFE9C2451C}" dt="2022-03-02T11:41:19.168" v="232" actId="571"/>
          <ac:spMkLst>
            <pc:docMk/>
            <pc:sldMk cId="3513509246" sldId="256"/>
            <ac:spMk id="28" creationId="{4932058E-A20F-4F48-953C-EDBFFCE96125}"/>
          </ac:spMkLst>
        </pc:spChg>
        <pc:spChg chg="mod topLvl">
          <ac:chgData name="CAMILA OSPINA AYALA" userId="78f2fe8b-a352-4d21-8a73-8c582c191c8b" providerId="ADAL" clId="{119E72F5-B702-4FC4-BA70-ABCFE9C2451C}" dt="2022-03-02T11:41:19.168" v="232" actId="571"/>
          <ac:spMkLst>
            <pc:docMk/>
            <pc:sldMk cId="3513509246" sldId="256"/>
            <ac:spMk id="29" creationId="{5751DFF6-0BE3-49DA-9152-418AC0EC2206}"/>
          </ac:spMkLst>
        </pc:spChg>
        <pc:spChg chg="mod">
          <ac:chgData name="CAMILA OSPINA AYALA" userId="78f2fe8b-a352-4d21-8a73-8c582c191c8b" providerId="ADAL" clId="{119E72F5-B702-4FC4-BA70-ABCFE9C2451C}" dt="2022-03-02T11:41:19.168" v="232" actId="571"/>
          <ac:spMkLst>
            <pc:docMk/>
            <pc:sldMk cId="3513509246" sldId="256"/>
            <ac:spMk id="30" creationId="{F3C4E3DD-1D10-4D5A-81CD-763ECE650A65}"/>
          </ac:spMkLst>
        </pc:spChg>
        <pc:spChg chg="mod">
          <ac:chgData name="CAMILA OSPINA AYALA" userId="78f2fe8b-a352-4d21-8a73-8c582c191c8b" providerId="ADAL" clId="{119E72F5-B702-4FC4-BA70-ABCFE9C2451C}" dt="2022-03-02T11:41:19.168" v="232" actId="571"/>
          <ac:spMkLst>
            <pc:docMk/>
            <pc:sldMk cId="3513509246" sldId="256"/>
            <ac:spMk id="31" creationId="{07AE9398-1881-469F-951D-29ADA2B178B6}"/>
          </ac:spMkLst>
        </pc:spChg>
        <pc:spChg chg="mod">
          <ac:chgData name="CAMILA OSPINA AYALA" userId="78f2fe8b-a352-4d21-8a73-8c582c191c8b" providerId="ADAL" clId="{119E72F5-B702-4FC4-BA70-ABCFE9C2451C}" dt="2022-03-02T11:41:56.189" v="237" actId="2711"/>
          <ac:spMkLst>
            <pc:docMk/>
            <pc:sldMk cId="3513509246" sldId="256"/>
            <ac:spMk id="32" creationId="{F663FA82-1B76-4B5E-939C-AED05F0BEF2C}"/>
          </ac:spMkLst>
        </pc:spChg>
        <pc:spChg chg="mod">
          <ac:chgData name="CAMILA OSPINA AYALA" userId="78f2fe8b-a352-4d21-8a73-8c582c191c8b" providerId="ADAL" clId="{119E72F5-B702-4FC4-BA70-ABCFE9C2451C}" dt="2022-03-02T11:41:56.189" v="237" actId="2711"/>
          <ac:spMkLst>
            <pc:docMk/>
            <pc:sldMk cId="3513509246" sldId="256"/>
            <ac:spMk id="33" creationId="{44C6A6F1-68BE-4290-B0AA-CE94068E701A}"/>
          </ac:spMkLst>
        </pc:spChg>
        <pc:spChg chg="mod topLvl">
          <ac:chgData name="CAMILA OSPINA AYALA" userId="78f2fe8b-a352-4d21-8a73-8c582c191c8b" providerId="ADAL" clId="{119E72F5-B702-4FC4-BA70-ABCFE9C2451C}" dt="2022-03-02T11:41:19.168" v="232" actId="571"/>
          <ac:spMkLst>
            <pc:docMk/>
            <pc:sldMk cId="3513509246" sldId="256"/>
            <ac:spMk id="34" creationId="{0CE25098-89F7-4813-B544-78663C75256E}"/>
          </ac:spMkLst>
        </pc:spChg>
        <pc:spChg chg="mod topLvl">
          <ac:chgData name="CAMILA OSPINA AYALA" userId="78f2fe8b-a352-4d21-8a73-8c582c191c8b" providerId="ADAL" clId="{119E72F5-B702-4FC4-BA70-ABCFE9C2451C}" dt="2022-03-02T11:41:19.168" v="232" actId="571"/>
          <ac:spMkLst>
            <pc:docMk/>
            <pc:sldMk cId="3513509246" sldId="256"/>
            <ac:spMk id="35" creationId="{2843D0DD-7137-4E59-8F50-E9A10B68152C}"/>
          </ac:spMkLst>
        </pc:spChg>
        <pc:spChg chg="add mod">
          <ac:chgData name="CAMILA OSPINA AYALA" userId="78f2fe8b-a352-4d21-8a73-8c582c191c8b" providerId="ADAL" clId="{119E72F5-B702-4FC4-BA70-ABCFE9C2451C}" dt="2022-03-02T11:38:08.681" v="180" actId="1076"/>
          <ac:spMkLst>
            <pc:docMk/>
            <pc:sldMk cId="3513509246" sldId="256"/>
            <ac:spMk id="37" creationId="{F8998751-4BDE-49F4-8B5B-A4EEE308E80B}"/>
          </ac:spMkLst>
        </pc:spChg>
        <pc:spChg chg="add del mod">
          <ac:chgData name="CAMILA OSPINA AYALA" userId="78f2fe8b-a352-4d21-8a73-8c582c191c8b" providerId="ADAL" clId="{119E72F5-B702-4FC4-BA70-ABCFE9C2451C}" dt="2022-03-02T11:35:41.084" v="176" actId="478"/>
          <ac:spMkLst>
            <pc:docMk/>
            <pc:sldMk cId="3513509246" sldId="256"/>
            <ac:spMk id="39" creationId="{F199FEEA-B6D0-4DE7-A878-A674D5C8A320}"/>
          </ac:spMkLst>
        </pc:spChg>
        <pc:spChg chg="add mod">
          <ac:chgData name="CAMILA OSPINA AYALA" userId="78f2fe8b-a352-4d21-8a73-8c582c191c8b" providerId="ADAL" clId="{119E72F5-B702-4FC4-BA70-ABCFE9C2451C}" dt="2022-03-02T11:40:51.346" v="229" actId="255"/>
          <ac:spMkLst>
            <pc:docMk/>
            <pc:sldMk cId="3513509246" sldId="256"/>
            <ac:spMk id="40" creationId="{F9AF426F-ACBD-4944-B0EA-BB8BB10D6D2D}"/>
          </ac:spMkLst>
        </pc:spChg>
        <pc:spChg chg="add mod">
          <ac:chgData name="CAMILA OSPINA AYALA" userId="78f2fe8b-a352-4d21-8a73-8c582c191c8b" providerId="ADAL" clId="{119E72F5-B702-4FC4-BA70-ABCFE9C2451C}" dt="2022-03-02T11:39:11.442" v="216" actId="1076"/>
          <ac:spMkLst>
            <pc:docMk/>
            <pc:sldMk cId="3513509246" sldId="256"/>
            <ac:spMk id="41" creationId="{8DE9B822-B5DE-4688-8146-5D508A74E52C}"/>
          </ac:spMkLst>
        </pc:spChg>
        <pc:spChg chg="add mod">
          <ac:chgData name="CAMILA OSPINA AYALA" userId="78f2fe8b-a352-4d21-8a73-8c582c191c8b" providerId="ADAL" clId="{119E72F5-B702-4FC4-BA70-ABCFE9C2451C}" dt="2022-03-02T11:40:53.631" v="230" actId="1076"/>
          <ac:spMkLst>
            <pc:docMk/>
            <pc:sldMk cId="3513509246" sldId="256"/>
            <ac:spMk id="42" creationId="{C0C8B480-951E-404C-ADEE-AAEB646375C9}"/>
          </ac:spMkLst>
        </pc:spChg>
        <pc:spChg chg="add mod">
          <ac:chgData name="CAMILA OSPINA AYALA" userId="78f2fe8b-a352-4d21-8a73-8c582c191c8b" providerId="ADAL" clId="{119E72F5-B702-4FC4-BA70-ABCFE9C2451C}" dt="2022-03-02T11:42:08.833" v="239" actId="2711"/>
          <ac:spMkLst>
            <pc:docMk/>
            <pc:sldMk cId="3513509246" sldId="256"/>
            <ac:spMk id="43" creationId="{1AF37114-BC5F-4F57-BC7F-204BB8359F58}"/>
          </ac:spMkLst>
        </pc:spChg>
        <pc:spChg chg="add mod">
          <ac:chgData name="CAMILA OSPINA AYALA" userId="78f2fe8b-a352-4d21-8a73-8c582c191c8b" providerId="ADAL" clId="{119E72F5-B702-4FC4-BA70-ABCFE9C2451C}" dt="2022-03-02T11:41:31.535" v="234" actId="2711"/>
          <ac:spMkLst>
            <pc:docMk/>
            <pc:sldMk cId="3513509246" sldId="256"/>
            <ac:spMk id="44" creationId="{8F2A4C48-C6B7-490A-972C-948D275D7A70}"/>
          </ac:spMkLst>
        </pc:spChg>
        <pc:grpChg chg="del mod topLvl">
          <ac:chgData name="CAMILA OSPINA AYALA" userId="78f2fe8b-a352-4d21-8a73-8c582c191c8b" providerId="ADAL" clId="{119E72F5-B702-4FC4-BA70-ABCFE9C2451C}" dt="2022-03-02T11:26:56.135" v="69" actId="165"/>
          <ac:grpSpMkLst>
            <pc:docMk/>
            <pc:sldMk cId="3513509246" sldId="256"/>
            <ac:grpSpMk id="2" creationId="{6927146B-06B4-41B4-AD3D-AA0F2FB64A1B}"/>
          </ac:grpSpMkLst>
        </pc:grpChg>
        <pc:grpChg chg="del mod">
          <ac:chgData name="CAMILA OSPINA AYALA" userId="78f2fe8b-a352-4d21-8a73-8c582c191c8b" providerId="ADAL" clId="{119E72F5-B702-4FC4-BA70-ABCFE9C2451C}" dt="2022-03-02T11:20:00.535" v="1" actId="165"/>
          <ac:grpSpMkLst>
            <pc:docMk/>
            <pc:sldMk cId="3513509246" sldId="256"/>
            <ac:grpSpMk id="7" creationId="{E21149BA-3532-482D-8897-6DA63790DBF6}"/>
          </ac:grpSpMkLst>
        </pc:grpChg>
        <pc:grpChg chg="add mod">
          <ac:chgData name="CAMILA OSPINA AYALA" userId="78f2fe8b-a352-4d21-8a73-8c582c191c8b" providerId="ADAL" clId="{119E72F5-B702-4FC4-BA70-ABCFE9C2451C}" dt="2022-03-02T11:21:40.142" v="23" actId="164"/>
          <ac:grpSpMkLst>
            <pc:docMk/>
            <pc:sldMk cId="3513509246" sldId="256"/>
            <ac:grpSpMk id="8" creationId="{A4B5AC5E-9B05-443E-AC47-05050B098A8D}"/>
          </ac:grpSpMkLst>
        </pc:grpChg>
        <pc:grpChg chg="add del mod">
          <ac:chgData name="CAMILA OSPINA AYALA" userId="78f2fe8b-a352-4d21-8a73-8c582c191c8b" providerId="ADAL" clId="{119E72F5-B702-4FC4-BA70-ABCFE9C2451C}" dt="2022-03-02T11:22:19.675" v="32" actId="165"/>
          <ac:grpSpMkLst>
            <pc:docMk/>
            <pc:sldMk cId="3513509246" sldId="256"/>
            <ac:grpSpMk id="9" creationId="{B0CAE914-00EC-47AB-B963-DBC2EAB07E8B}"/>
          </ac:grpSpMkLst>
        </pc:grpChg>
        <pc:grpChg chg="add mod">
          <ac:chgData name="CAMILA OSPINA AYALA" userId="78f2fe8b-a352-4d21-8a73-8c582c191c8b" providerId="ADAL" clId="{119E72F5-B702-4FC4-BA70-ABCFE9C2451C}" dt="2022-03-02T11:41:19.168" v="232" actId="571"/>
          <ac:grpSpMkLst>
            <pc:docMk/>
            <pc:sldMk cId="3513509246" sldId="256"/>
            <ac:grpSpMk id="10" creationId="{5A5F787B-1898-4754-B07F-ABBA3A4EEDFA}"/>
          </ac:grpSpMkLst>
        </pc:grpChg>
        <pc:grpChg chg="mod">
          <ac:chgData name="CAMILA OSPINA AYALA" userId="78f2fe8b-a352-4d21-8a73-8c582c191c8b" providerId="ADAL" clId="{119E72F5-B702-4FC4-BA70-ABCFE9C2451C}" dt="2022-03-02T11:41:19.168" v="232" actId="571"/>
          <ac:grpSpMkLst>
            <pc:docMk/>
            <pc:sldMk cId="3513509246" sldId="256"/>
            <ac:grpSpMk id="15" creationId="{7E83C65F-6016-4224-B46D-4B3AC52081C9}"/>
          </ac:grpSpMkLst>
        </pc:grpChg>
        <pc:grpChg chg="mod topLvl">
          <ac:chgData name="CAMILA OSPINA AYALA" userId="78f2fe8b-a352-4d21-8a73-8c582c191c8b" providerId="ADAL" clId="{119E72F5-B702-4FC4-BA70-ABCFE9C2451C}" dt="2022-03-02T11:41:19.168" v="232" actId="571"/>
          <ac:grpSpMkLst>
            <pc:docMk/>
            <pc:sldMk cId="3513509246" sldId="256"/>
            <ac:grpSpMk id="16" creationId="{5BD62117-51CC-49FD-9B14-D0BD3D7E5606}"/>
          </ac:grpSpMkLst>
        </pc:grpChg>
        <pc:picChg chg="mod">
          <ac:chgData name="CAMILA OSPINA AYALA" userId="78f2fe8b-a352-4d21-8a73-8c582c191c8b" providerId="ADAL" clId="{119E72F5-B702-4FC4-BA70-ABCFE9C2451C}" dt="2022-03-02T11:41:19.168" v="232" actId="571"/>
          <ac:picMkLst>
            <pc:docMk/>
            <pc:sldMk cId="3513509246" sldId="256"/>
            <ac:picMk id="3" creationId="{2748FDED-478B-4CD4-B3DF-3EB6DA924E4F}"/>
          </ac:picMkLst>
        </pc:picChg>
        <pc:picChg chg="del mod topLvl">
          <ac:chgData name="CAMILA OSPINA AYALA" userId="78f2fe8b-a352-4d21-8a73-8c582c191c8b" providerId="ADAL" clId="{119E72F5-B702-4FC4-BA70-ABCFE9C2451C}" dt="2022-03-02T11:20:16.751" v="4" actId="478"/>
          <ac:picMkLst>
            <pc:docMk/>
            <pc:sldMk cId="3513509246" sldId="256"/>
            <ac:picMk id="5" creationId="{66DB4737-9EAD-4970-8CF2-92916B86221E}"/>
          </ac:picMkLst>
        </pc:picChg>
        <pc:picChg chg="add mod topLvl">
          <ac:chgData name="CAMILA OSPINA AYALA" userId="78f2fe8b-a352-4d21-8a73-8c582c191c8b" providerId="ADAL" clId="{119E72F5-B702-4FC4-BA70-ABCFE9C2451C}" dt="2022-03-02T11:41:19.168" v="232" actId="571"/>
          <ac:picMkLst>
            <pc:docMk/>
            <pc:sldMk cId="3513509246" sldId="256"/>
            <ac:picMk id="6" creationId="{E55A6CA6-9A26-4290-AD17-4B3C816ECF4F}"/>
          </ac:picMkLst>
        </pc:picChg>
        <pc:picChg chg="mod">
          <ac:chgData name="CAMILA OSPINA AYALA" userId="78f2fe8b-a352-4d21-8a73-8c582c191c8b" providerId="ADAL" clId="{119E72F5-B702-4FC4-BA70-ABCFE9C2451C}" dt="2022-03-02T11:41:19.168" v="232" actId="571"/>
          <ac:picMkLst>
            <pc:docMk/>
            <pc:sldMk cId="3513509246" sldId="256"/>
            <ac:picMk id="18" creationId="{5E2E3BE4-D8DF-45CE-80E8-69E01C751179}"/>
          </ac:picMkLst>
        </pc:picChg>
        <pc:picChg chg="mod">
          <ac:chgData name="CAMILA OSPINA AYALA" userId="78f2fe8b-a352-4d21-8a73-8c582c191c8b" providerId="ADAL" clId="{119E72F5-B702-4FC4-BA70-ABCFE9C2451C}" dt="2022-03-02T11:41:19.168" v="232" actId="571"/>
          <ac:picMkLst>
            <pc:docMk/>
            <pc:sldMk cId="3513509246" sldId="256"/>
            <ac:picMk id="20" creationId="{D2B966CF-BD00-4476-8C77-EE159EC54D2D}"/>
          </ac:picMkLst>
        </pc:picChg>
        <pc:picChg chg="mod">
          <ac:chgData name="CAMILA OSPINA AYALA" userId="78f2fe8b-a352-4d21-8a73-8c582c191c8b" providerId="ADAL" clId="{119E72F5-B702-4FC4-BA70-ABCFE9C2451C}" dt="2022-03-02T11:41:19.168" v="232" actId="571"/>
          <ac:picMkLst>
            <pc:docMk/>
            <pc:sldMk cId="3513509246" sldId="256"/>
            <ac:picMk id="22" creationId="{36557F51-4591-406D-A74B-AA0F86974730}"/>
          </ac:picMkLst>
        </pc:picChg>
        <pc:picChg chg="mod">
          <ac:chgData name="CAMILA OSPINA AYALA" userId="78f2fe8b-a352-4d21-8a73-8c582c191c8b" providerId="ADAL" clId="{119E72F5-B702-4FC4-BA70-ABCFE9C2451C}" dt="2022-03-02T11:41:19.168" v="232" actId="571"/>
          <ac:picMkLst>
            <pc:docMk/>
            <pc:sldMk cId="3513509246" sldId="256"/>
            <ac:picMk id="24" creationId="{53327AEA-8B5E-4FB8-94DB-CA62964753AB}"/>
          </ac:picMkLst>
        </pc:picChg>
        <pc:picChg chg="add mod topLvl">
          <ac:chgData name="CAMILA OSPINA AYALA" userId="78f2fe8b-a352-4d21-8a73-8c582c191c8b" providerId="ADAL" clId="{119E72F5-B702-4FC4-BA70-ABCFE9C2451C}" dt="2022-03-02T11:41:19.168" v="232" actId="571"/>
          <ac:picMkLst>
            <pc:docMk/>
            <pc:sldMk cId="3513509246" sldId="256"/>
            <ac:picMk id="36" creationId="{C3CE8CD4-2A9C-4FBB-87C5-0BB7522E4DDC}"/>
          </ac:picMkLst>
        </pc:picChg>
        <pc:picChg chg="del mod topLvl">
          <ac:chgData name="CAMILA OSPINA AYALA" userId="78f2fe8b-a352-4d21-8a73-8c582c191c8b" providerId="ADAL" clId="{119E72F5-B702-4FC4-BA70-ABCFE9C2451C}" dt="2022-03-02T11:20:04.717" v="2" actId="478"/>
          <ac:picMkLst>
            <pc:docMk/>
            <pc:sldMk cId="3513509246" sldId="256"/>
            <ac:picMk id="38" creationId="{A5C773F6-DFC6-4812-8DDD-69F6040F032A}"/>
          </ac:picMkLst>
        </pc:picChg>
      </pc:sldChg>
    </pc:docChg>
  </pc:docChgLst>
  <pc:docChgLst>
    <pc:chgData name="CAMILA OSPINA AYALA" userId="78f2fe8b-a352-4d21-8a73-8c582c191c8b" providerId="ADAL" clId="{C9456DFD-2B99-4C20-9354-113702F89BE9}"/>
    <pc:docChg chg="custSel modSld">
      <pc:chgData name="CAMILA OSPINA AYALA" userId="78f2fe8b-a352-4d21-8a73-8c582c191c8b" providerId="ADAL" clId="{C9456DFD-2B99-4C20-9354-113702F89BE9}" dt="2022-03-02T10:39:11.592" v="26" actId="14100"/>
      <pc:docMkLst>
        <pc:docMk/>
      </pc:docMkLst>
      <pc:sldChg chg="addSp delSp modSp mod">
        <pc:chgData name="CAMILA OSPINA AYALA" userId="78f2fe8b-a352-4d21-8a73-8c582c191c8b" providerId="ADAL" clId="{C9456DFD-2B99-4C20-9354-113702F89BE9}" dt="2022-03-02T10:39:11.592" v="26" actId="14100"/>
        <pc:sldMkLst>
          <pc:docMk/>
          <pc:sldMk cId="3513509246" sldId="256"/>
        </pc:sldMkLst>
        <pc:picChg chg="add del mod ord">
          <ac:chgData name="CAMILA OSPINA AYALA" userId="78f2fe8b-a352-4d21-8a73-8c582c191c8b" providerId="ADAL" clId="{C9456DFD-2B99-4C20-9354-113702F89BE9}" dt="2022-03-02T10:37:25.286" v="13" actId="478"/>
          <ac:picMkLst>
            <pc:docMk/>
            <pc:sldMk cId="3513509246" sldId="256"/>
            <ac:picMk id="4" creationId="{58313F84-236F-4B24-8DFB-60FBEA131F99}"/>
          </ac:picMkLst>
        </pc:picChg>
        <pc:picChg chg="add del mod">
          <ac:chgData name="CAMILA OSPINA AYALA" userId="78f2fe8b-a352-4d21-8a73-8c582c191c8b" providerId="ADAL" clId="{C9456DFD-2B99-4C20-9354-113702F89BE9}" dt="2022-03-02T10:38:13.560" v="17" actId="478"/>
          <ac:picMkLst>
            <pc:docMk/>
            <pc:sldMk cId="3513509246" sldId="256"/>
            <ac:picMk id="5" creationId="{125CB0B7-234B-43A4-A83D-0463019B9616}"/>
          </ac:picMkLst>
        </pc:picChg>
        <pc:picChg chg="del">
          <ac:chgData name="CAMILA OSPINA AYALA" userId="78f2fe8b-a352-4d21-8a73-8c582c191c8b" providerId="ADAL" clId="{C9456DFD-2B99-4C20-9354-113702F89BE9}" dt="2022-03-02T02:55:14.687" v="0" actId="478"/>
          <ac:picMkLst>
            <pc:docMk/>
            <pc:sldMk cId="3513509246" sldId="256"/>
            <ac:picMk id="5" creationId="{9CD7E43F-978E-49CB-B105-04AED7AC3AD5}"/>
          </ac:picMkLst>
        </pc:picChg>
        <pc:picChg chg="add mod ord">
          <ac:chgData name="CAMILA OSPINA AYALA" userId="78f2fe8b-a352-4d21-8a73-8c582c191c8b" providerId="ADAL" clId="{C9456DFD-2B99-4C20-9354-113702F89BE9}" dt="2022-03-02T10:39:11.592" v="26" actId="14100"/>
          <ac:picMkLst>
            <pc:docMk/>
            <pc:sldMk cId="3513509246" sldId="256"/>
            <ac:picMk id="7" creationId="{87477C72-F0F7-4B37-A057-6FF4500B3AC3}"/>
          </ac:picMkLst>
        </pc:picChg>
      </pc:sldChg>
    </pc:docChg>
  </pc:docChgLst>
  <pc:docChgLst>
    <pc:chgData name="CAMILA OSPINA AYALA" userId="78f2fe8b-a352-4d21-8a73-8c582c191c8b" providerId="ADAL" clId="{CC91BA5C-4D86-443C-A7CF-3306F6998EB7}"/>
    <pc:docChg chg="undo custSel modSld">
      <pc:chgData name="CAMILA OSPINA AYALA" userId="78f2fe8b-a352-4d21-8a73-8c582c191c8b" providerId="ADAL" clId="{CC91BA5C-4D86-443C-A7CF-3306F6998EB7}" dt="2022-03-02T19:06:23.437" v="155" actId="20577"/>
      <pc:docMkLst>
        <pc:docMk/>
      </pc:docMkLst>
      <pc:sldChg chg="addSp delSp modSp mod">
        <pc:chgData name="CAMILA OSPINA AYALA" userId="78f2fe8b-a352-4d21-8a73-8c582c191c8b" providerId="ADAL" clId="{CC91BA5C-4D86-443C-A7CF-3306F6998EB7}" dt="2022-03-02T19:06:23.437" v="155" actId="20577"/>
        <pc:sldMkLst>
          <pc:docMk/>
          <pc:sldMk cId="3513509246" sldId="256"/>
        </pc:sldMkLst>
        <pc:spChg chg="mod">
          <ac:chgData name="CAMILA OSPINA AYALA" userId="78f2fe8b-a352-4d21-8a73-8c582c191c8b" providerId="ADAL" clId="{CC91BA5C-4D86-443C-A7CF-3306F6998EB7}" dt="2022-03-02T11:43:28.770" v="0" actId="165"/>
          <ac:spMkLst>
            <pc:docMk/>
            <pc:sldMk cId="3513509246" sldId="256"/>
            <ac:spMk id="14" creationId="{559545BB-4BA5-4679-B338-FBC782E75B16}"/>
          </ac:spMkLst>
        </pc:spChg>
        <pc:spChg chg="mod topLvl">
          <ac:chgData name="CAMILA OSPINA AYALA" userId="78f2fe8b-a352-4d21-8a73-8c582c191c8b" providerId="ADAL" clId="{CC91BA5C-4D86-443C-A7CF-3306F6998EB7}" dt="2022-03-02T17:54:55.830" v="151" actId="164"/>
          <ac:spMkLst>
            <pc:docMk/>
            <pc:sldMk cId="3513509246" sldId="256"/>
            <ac:spMk id="19" creationId="{AC4C3DC5-C950-4469-B152-4E43DE1B5036}"/>
          </ac:spMkLst>
        </pc:spChg>
        <pc:spChg chg="mod topLvl">
          <ac:chgData name="CAMILA OSPINA AYALA" userId="78f2fe8b-a352-4d21-8a73-8c582c191c8b" providerId="ADAL" clId="{CC91BA5C-4D86-443C-A7CF-3306F6998EB7}" dt="2022-03-02T17:54:55.830" v="151" actId="164"/>
          <ac:spMkLst>
            <pc:docMk/>
            <pc:sldMk cId="3513509246" sldId="256"/>
            <ac:spMk id="21" creationId="{1CA3E8AA-CACE-4939-89EE-2E2C569FA7D2}"/>
          </ac:spMkLst>
        </pc:spChg>
        <pc:spChg chg="mod topLvl">
          <ac:chgData name="CAMILA OSPINA AYALA" userId="78f2fe8b-a352-4d21-8a73-8c582c191c8b" providerId="ADAL" clId="{CC91BA5C-4D86-443C-A7CF-3306F6998EB7}" dt="2022-03-02T17:54:55.830" v="151" actId="164"/>
          <ac:spMkLst>
            <pc:docMk/>
            <pc:sldMk cId="3513509246" sldId="256"/>
            <ac:spMk id="23" creationId="{2223FC15-4D9E-4B6E-8A58-F6F5B19D2659}"/>
          </ac:spMkLst>
        </pc:spChg>
        <pc:spChg chg="mod topLvl">
          <ac:chgData name="CAMILA OSPINA AYALA" userId="78f2fe8b-a352-4d21-8a73-8c582c191c8b" providerId="ADAL" clId="{CC91BA5C-4D86-443C-A7CF-3306F6998EB7}" dt="2022-03-02T17:54:55.830" v="151" actId="164"/>
          <ac:spMkLst>
            <pc:docMk/>
            <pc:sldMk cId="3513509246" sldId="256"/>
            <ac:spMk id="25" creationId="{599088B4-5A7A-4909-B659-A569413595EE}"/>
          </ac:spMkLst>
        </pc:spChg>
        <pc:spChg chg="mod topLvl">
          <ac:chgData name="CAMILA OSPINA AYALA" userId="78f2fe8b-a352-4d21-8a73-8c582c191c8b" providerId="ADAL" clId="{CC91BA5C-4D86-443C-A7CF-3306F6998EB7}" dt="2022-03-02T17:54:55.830" v="151" actId="164"/>
          <ac:spMkLst>
            <pc:docMk/>
            <pc:sldMk cId="3513509246" sldId="256"/>
            <ac:spMk id="26" creationId="{000E1D5E-750D-4A86-887D-B8AE804C8B3B}"/>
          </ac:spMkLst>
        </pc:spChg>
        <pc:spChg chg="mod topLvl">
          <ac:chgData name="CAMILA OSPINA AYALA" userId="78f2fe8b-a352-4d21-8a73-8c582c191c8b" providerId="ADAL" clId="{CC91BA5C-4D86-443C-A7CF-3306F6998EB7}" dt="2022-03-02T17:54:55.830" v="151" actId="164"/>
          <ac:spMkLst>
            <pc:docMk/>
            <pc:sldMk cId="3513509246" sldId="256"/>
            <ac:spMk id="27" creationId="{EDE3F7CC-9264-4DB8-90A9-8EF5F9D9F236}"/>
          </ac:spMkLst>
        </pc:spChg>
        <pc:spChg chg="mod topLvl">
          <ac:chgData name="CAMILA OSPINA AYALA" userId="78f2fe8b-a352-4d21-8a73-8c582c191c8b" providerId="ADAL" clId="{CC91BA5C-4D86-443C-A7CF-3306F6998EB7}" dt="2022-03-02T17:54:55.830" v="151" actId="164"/>
          <ac:spMkLst>
            <pc:docMk/>
            <pc:sldMk cId="3513509246" sldId="256"/>
            <ac:spMk id="28" creationId="{4932058E-A20F-4F48-953C-EDBFFCE96125}"/>
          </ac:spMkLst>
        </pc:spChg>
        <pc:spChg chg="mod topLvl">
          <ac:chgData name="CAMILA OSPINA AYALA" userId="78f2fe8b-a352-4d21-8a73-8c582c191c8b" providerId="ADAL" clId="{CC91BA5C-4D86-443C-A7CF-3306F6998EB7}" dt="2022-03-02T17:54:55.830" v="151" actId="164"/>
          <ac:spMkLst>
            <pc:docMk/>
            <pc:sldMk cId="3513509246" sldId="256"/>
            <ac:spMk id="29" creationId="{5751DFF6-0BE3-49DA-9152-418AC0EC2206}"/>
          </ac:spMkLst>
        </pc:spChg>
        <pc:spChg chg="mod">
          <ac:chgData name="CAMILA OSPINA AYALA" userId="78f2fe8b-a352-4d21-8a73-8c582c191c8b" providerId="ADAL" clId="{CC91BA5C-4D86-443C-A7CF-3306F6998EB7}" dt="2022-03-02T11:43:28.770" v="0" actId="165"/>
          <ac:spMkLst>
            <pc:docMk/>
            <pc:sldMk cId="3513509246" sldId="256"/>
            <ac:spMk id="30" creationId="{F3C4E3DD-1D10-4D5A-81CD-763ECE650A65}"/>
          </ac:spMkLst>
        </pc:spChg>
        <pc:spChg chg="mod">
          <ac:chgData name="CAMILA OSPINA AYALA" userId="78f2fe8b-a352-4d21-8a73-8c582c191c8b" providerId="ADAL" clId="{CC91BA5C-4D86-443C-A7CF-3306F6998EB7}" dt="2022-03-02T11:43:28.770" v="0" actId="165"/>
          <ac:spMkLst>
            <pc:docMk/>
            <pc:sldMk cId="3513509246" sldId="256"/>
            <ac:spMk id="31" creationId="{07AE9398-1881-469F-951D-29ADA2B178B6}"/>
          </ac:spMkLst>
        </pc:spChg>
        <pc:spChg chg="mod">
          <ac:chgData name="CAMILA OSPINA AYALA" userId="78f2fe8b-a352-4d21-8a73-8c582c191c8b" providerId="ADAL" clId="{CC91BA5C-4D86-443C-A7CF-3306F6998EB7}" dt="2022-03-02T11:43:28.770" v="0" actId="165"/>
          <ac:spMkLst>
            <pc:docMk/>
            <pc:sldMk cId="3513509246" sldId="256"/>
            <ac:spMk id="32" creationId="{F663FA82-1B76-4B5E-939C-AED05F0BEF2C}"/>
          </ac:spMkLst>
        </pc:spChg>
        <pc:spChg chg="mod">
          <ac:chgData name="CAMILA OSPINA AYALA" userId="78f2fe8b-a352-4d21-8a73-8c582c191c8b" providerId="ADAL" clId="{CC91BA5C-4D86-443C-A7CF-3306F6998EB7}" dt="2022-03-02T11:43:28.770" v="0" actId="165"/>
          <ac:spMkLst>
            <pc:docMk/>
            <pc:sldMk cId="3513509246" sldId="256"/>
            <ac:spMk id="33" creationId="{44C6A6F1-68BE-4290-B0AA-CE94068E701A}"/>
          </ac:spMkLst>
        </pc:spChg>
        <pc:spChg chg="mod topLvl">
          <ac:chgData name="CAMILA OSPINA AYALA" userId="78f2fe8b-a352-4d21-8a73-8c582c191c8b" providerId="ADAL" clId="{CC91BA5C-4D86-443C-A7CF-3306F6998EB7}" dt="2022-03-02T17:54:55.830" v="151" actId="164"/>
          <ac:spMkLst>
            <pc:docMk/>
            <pc:sldMk cId="3513509246" sldId="256"/>
            <ac:spMk id="34" creationId="{0CE25098-89F7-4813-B544-78663C75256E}"/>
          </ac:spMkLst>
        </pc:spChg>
        <pc:spChg chg="mod topLvl">
          <ac:chgData name="CAMILA OSPINA AYALA" userId="78f2fe8b-a352-4d21-8a73-8c582c191c8b" providerId="ADAL" clId="{CC91BA5C-4D86-443C-A7CF-3306F6998EB7}" dt="2022-03-02T17:54:55.830" v="151" actId="164"/>
          <ac:spMkLst>
            <pc:docMk/>
            <pc:sldMk cId="3513509246" sldId="256"/>
            <ac:spMk id="35" creationId="{2843D0DD-7137-4E59-8F50-E9A10B68152C}"/>
          </ac:spMkLst>
        </pc:spChg>
        <pc:spChg chg="add mod">
          <ac:chgData name="CAMILA OSPINA AYALA" userId="78f2fe8b-a352-4d21-8a73-8c582c191c8b" providerId="ADAL" clId="{CC91BA5C-4D86-443C-A7CF-3306F6998EB7}" dt="2022-03-02T17:28:08.696" v="85" actId="164"/>
          <ac:spMkLst>
            <pc:docMk/>
            <pc:sldMk cId="3513509246" sldId="256"/>
            <ac:spMk id="36" creationId="{D230DE21-C5E1-480F-9D31-B83499BD0BDA}"/>
          </ac:spMkLst>
        </pc:spChg>
        <pc:spChg chg="mod">
          <ac:chgData name="CAMILA OSPINA AYALA" userId="78f2fe8b-a352-4d21-8a73-8c582c191c8b" providerId="ADAL" clId="{CC91BA5C-4D86-443C-A7CF-3306F6998EB7}" dt="2022-03-02T19:06:23.437" v="155" actId="20577"/>
          <ac:spMkLst>
            <pc:docMk/>
            <pc:sldMk cId="3513509246" sldId="256"/>
            <ac:spMk id="37" creationId="{F8998751-4BDE-49F4-8B5B-A4EEE308E80B}"/>
          </ac:spMkLst>
        </pc:spChg>
        <pc:spChg chg="mod">
          <ac:chgData name="CAMILA OSPINA AYALA" userId="78f2fe8b-a352-4d21-8a73-8c582c191c8b" providerId="ADAL" clId="{CC91BA5C-4D86-443C-A7CF-3306F6998EB7}" dt="2022-03-02T11:44:40.804" v="34" actId="1076"/>
          <ac:spMkLst>
            <pc:docMk/>
            <pc:sldMk cId="3513509246" sldId="256"/>
            <ac:spMk id="40" creationId="{F9AF426F-ACBD-4944-B0EA-BB8BB10D6D2D}"/>
          </ac:spMkLst>
        </pc:spChg>
        <pc:spChg chg="mod">
          <ac:chgData name="CAMILA OSPINA AYALA" userId="78f2fe8b-a352-4d21-8a73-8c582c191c8b" providerId="ADAL" clId="{CC91BA5C-4D86-443C-A7CF-3306F6998EB7}" dt="2022-03-02T11:44:48.343" v="35" actId="1076"/>
          <ac:spMkLst>
            <pc:docMk/>
            <pc:sldMk cId="3513509246" sldId="256"/>
            <ac:spMk id="41" creationId="{8DE9B822-B5DE-4688-8146-5D508A74E52C}"/>
          </ac:spMkLst>
        </pc:spChg>
        <pc:spChg chg="mod">
          <ac:chgData name="CAMILA OSPINA AYALA" userId="78f2fe8b-a352-4d21-8a73-8c582c191c8b" providerId="ADAL" clId="{CC91BA5C-4D86-443C-A7CF-3306F6998EB7}" dt="2022-03-02T11:43:28.770" v="0" actId="165"/>
          <ac:spMkLst>
            <pc:docMk/>
            <pc:sldMk cId="3513509246" sldId="256"/>
            <ac:spMk id="43" creationId="{1AF37114-BC5F-4F57-BC7F-204BB8359F58}"/>
          </ac:spMkLst>
        </pc:spChg>
        <pc:spChg chg="mod">
          <ac:chgData name="CAMILA OSPINA AYALA" userId="78f2fe8b-a352-4d21-8a73-8c582c191c8b" providerId="ADAL" clId="{CC91BA5C-4D86-443C-A7CF-3306F6998EB7}" dt="2022-03-02T11:43:28.770" v="0" actId="165"/>
          <ac:spMkLst>
            <pc:docMk/>
            <pc:sldMk cId="3513509246" sldId="256"/>
            <ac:spMk id="44" creationId="{8F2A4C48-C6B7-490A-972C-948D275D7A70}"/>
          </ac:spMkLst>
        </pc:spChg>
        <pc:spChg chg="add del mod">
          <ac:chgData name="CAMILA OSPINA AYALA" userId="78f2fe8b-a352-4d21-8a73-8c582c191c8b" providerId="ADAL" clId="{CC91BA5C-4D86-443C-A7CF-3306F6998EB7}" dt="2022-03-02T17:28:08.696" v="85" actId="164"/>
          <ac:spMkLst>
            <pc:docMk/>
            <pc:sldMk cId="3513509246" sldId="256"/>
            <ac:spMk id="45" creationId="{0D078D83-0224-46FA-91FE-0A916212D302}"/>
          </ac:spMkLst>
        </pc:spChg>
        <pc:spChg chg="add del mod">
          <ac:chgData name="CAMILA OSPINA AYALA" userId="78f2fe8b-a352-4d21-8a73-8c582c191c8b" providerId="ADAL" clId="{CC91BA5C-4D86-443C-A7CF-3306F6998EB7}" dt="2022-03-02T17:27:05.030" v="72"/>
          <ac:spMkLst>
            <pc:docMk/>
            <pc:sldMk cId="3513509246" sldId="256"/>
            <ac:spMk id="46" creationId="{6B2BD4FC-2A3E-4392-8083-C327267CADC9}"/>
          </ac:spMkLst>
        </pc:spChg>
        <pc:spChg chg="add mod">
          <ac:chgData name="CAMILA OSPINA AYALA" userId="78f2fe8b-a352-4d21-8a73-8c582c191c8b" providerId="ADAL" clId="{CC91BA5C-4D86-443C-A7CF-3306F6998EB7}" dt="2022-03-02T17:28:08.696" v="85" actId="164"/>
          <ac:spMkLst>
            <pc:docMk/>
            <pc:sldMk cId="3513509246" sldId="256"/>
            <ac:spMk id="47" creationId="{D92C0AD5-AD7C-49A1-B42A-B05405678E4C}"/>
          </ac:spMkLst>
        </pc:spChg>
        <pc:spChg chg="add mod">
          <ac:chgData name="CAMILA OSPINA AYALA" userId="78f2fe8b-a352-4d21-8a73-8c582c191c8b" providerId="ADAL" clId="{CC91BA5C-4D86-443C-A7CF-3306F6998EB7}" dt="2022-03-02T17:55:06.220" v="152" actId="164"/>
          <ac:spMkLst>
            <pc:docMk/>
            <pc:sldMk cId="3513509246" sldId="256"/>
            <ac:spMk id="48" creationId="{08B0B275-7C47-4899-94A2-863FA4B60537}"/>
          </ac:spMkLst>
        </pc:spChg>
        <pc:spChg chg="mod">
          <ac:chgData name="CAMILA OSPINA AYALA" userId="78f2fe8b-a352-4d21-8a73-8c582c191c8b" providerId="ADAL" clId="{CC91BA5C-4D86-443C-A7CF-3306F6998EB7}" dt="2022-03-02T17:35:21.512" v="98" actId="2711"/>
          <ac:spMkLst>
            <pc:docMk/>
            <pc:sldMk cId="3513509246" sldId="256"/>
            <ac:spMk id="51" creationId="{5A1E0F5C-1CD8-42DE-855C-785AE1404351}"/>
          </ac:spMkLst>
        </pc:spChg>
        <pc:spChg chg="mod">
          <ac:chgData name="CAMILA OSPINA AYALA" userId="78f2fe8b-a352-4d21-8a73-8c582c191c8b" providerId="ADAL" clId="{CC91BA5C-4D86-443C-A7CF-3306F6998EB7}" dt="2022-03-02T17:35:21.512" v="98" actId="2711"/>
          <ac:spMkLst>
            <pc:docMk/>
            <pc:sldMk cId="3513509246" sldId="256"/>
            <ac:spMk id="52" creationId="{88499277-84D9-448B-AAF4-ADECF5F236BB}"/>
          </ac:spMkLst>
        </pc:spChg>
        <pc:spChg chg="mod">
          <ac:chgData name="CAMILA OSPINA AYALA" userId="78f2fe8b-a352-4d21-8a73-8c582c191c8b" providerId="ADAL" clId="{CC91BA5C-4D86-443C-A7CF-3306F6998EB7}" dt="2022-03-02T17:35:21.512" v="98" actId="2711"/>
          <ac:spMkLst>
            <pc:docMk/>
            <pc:sldMk cId="3513509246" sldId="256"/>
            <ac:spMk id="58" creationId="{FFC6DD75-40B0-4ACE-A17E-21A7BECD6CFE}"/>
          </ac:spMkLst>
        </pc:spChg>
        <pc:spChg chg="mod">
          <ac:chgData name="CAMILA OSPINA AYALA" userId="78f2fe8b-a352-4d21-8a73-8c582c191c8b" providerId="ADAL" clId="{CC91BA5C-4D86-443C-A7CF-3306F6998EB7}" dt="2022-03-02T17:35:21.512" v="98" actId="2711"/>
          <ac:spMkLst>
            <pc:docMk/>
            <pc:sldMk cId="3513509246" sldId="256"/>
            <ac:spMk id="59" creationId="{11668080-0518-498F-A430-481348DD2716}"/>
          </ac:spMkLst>
        </pc:spChg>
        <pc:spChg chg="mod">
          <ac:chgData name="CAMILA OSPINA AYALA" userId="78f2fe8b-a352-4d21-8a73-8c582c191c8b" providerId="ADAL" clId="{CC91BA5C-4D86-443C-A7CF-3306F6998EB7}" dt="2022-03-02T17:35:21.512" v="98" actId="2711"/>
          <ac:spMkLst>
            <pc:docMk/>
            <pc:sldMk cId="3513509246" sldId="256"/>
            <ac:spMk id="60" creationId="{73BFA8CB-37F7-4F3B-A9B0-BF70299C82F4}"/>
          </ac:spMkLst>
        </pc:spChg>
        <pc:spChg chg="mod">
          <ac:chgData name="CAMILA OSPINA AYALA" userId="78f2fe8b-a352-4d21-8a73-8c582c191c8b" providerId="ADAL" clId="{CC91BA5C-4D86-443C-A7CF-3306F6998EB7}" dt="2022-03-02T17:35:21.512" v="98" actId="2711"/>
          <ac:spMkLst>
            <pc:docMk/>
            <pc:sldMk cId="3513509246" sldId="256"/>
            <ac:spMk id="61" creationId="{A297613B-B327-46D7-94C4-B364628C4C81}"/>
          </ac:spMkLst>
        </pc:spChg>
        <pc:spChg chg="mod">
          <ac:chgData name="CAMILA OSPINA AYALA" userId="78f2fe8b-a352-4d21-8a73-8c582c191c8b" providerId="ADAL" clId="{CC91BA5C-4D86-443C-A7CF-3306F6998EB7}" dt="2022-03-02T17:35:21.512" v="98" actId="2711"/>
          <ac:spMkLst>
            <pc:docMk/>
            <pc:sldMk cId="3513509246" sldId="256"/>
            <ac:spMk id="63" creationId="{41FC9007-EE5C-4979-92D1-FD6D1CC476AF}"/>
          </ac:spMkLst>
        </pc:spChg>
        <pc:spChg chg="add mod">
          <ac:chgData name="CAMILA OSPINA AYALA" userId="78f2fe8b-a352-4d21-8a73-8c582c191c8b" providerId="ADAL" clId="{CC91BA5C-4D86-443C-A7CF-3306F6998EB7}" dt="2022-03-02T17:40:19.623" v="134" actId="164"/>
          <ac:spMkLst>
            <pc:docMk/>
            <pc:sldMk cId="3513509246" sldId="256"/>
            <ac:spMk id="64" creationId="{401326BD-EB88-417D-8D4D-D2FA2936BED1}"/>
          </ac:spMkLst>
        </pc:spChg>
        <pc:spChg chg="add mod">
          <ac:chgData name="CAMILA OSPINA AYALA" userId="78f2fe8b-a352-4d21-8a73-8c582c191c8b" providerId="ADAL" clId="{CC91BA5C-4D86-443C-A7CF-3306F6998EB7}" dt="2022-03-02T17:40:24.639" v="135" actId="14100"/>
          <ac:spMkLst>
            <pc:docMk/>
            <pc:sldMk cId="3513509246" sldId="256"/>
            <ac:spMk id="65" creationId="{95764C5A-11C2-4D84-97AD-0DA4244FC029}"/>
          </ac:spMkLst>
        </pc:spChg>
        <pc:spChg chg="add mod">
          <ac:chgData name="CAMILA OSPINA AYALA" userId="78f2fe8b-a352-4d21-8a73-8c582c191c8b" providerId="ADAL" clId="{CC91BA5C-4D86-443C-A7CF-3306F6998EB7}" dt="2022-03-02T17:41:21.055" v="149" actId="164"/>
          <ac:spMkLst>
            <pc:docMk/>
            <pc:sldMk cId="3513509246" sldId="256"/>
            <ac:spMk id="67" creationId="{67CD50A1-6B7A-447E-9A01-26CB9390E2BE}"/>
          </ac:spMkLst>
        </pc:spChg>
        <pc:grpChg chg="add mod">
          <ac:chgData name="CAMILA OSPINA AYALA" userId="78f2fe8b-a352-4d21-8a73-8c582c191c8b" providerId="ADAL" clId="{CC91BA5C-4D86-443C-A7CF-3306F6998EB7}" dt="2022-03-02T17:55:06.220" v="152" actId="164"/>
          <ac:grpSpMkLst>
            <pc:docMk/>
            <pc:sldMk cId="3513509246" sldId="256"/>
            <ac:grpSpMk id="7" creationId="{9076C046-96DD-4900-8425-A1C84D54CDA0}"/>
          </ac:grpSpMkLst>
        </pc:grpChg>
        <pc:grpChg chg="del">
          <ac:chgData name="CAMILA OSPINA AYALA" userId="78f2fe8b-a352-4d21-8a73-8c582c191c8b" providerId="ADAL" clId="{CC91BA5C-4D86-443C-A7CF-3306F6998EB7}" dt="2022-03-02T11:43:28.770" v="0" actId="165"/>
          <ac:grpSpMkLst>
            <pc:docMk/>
            <pc:sldMk cId="3513509246" sldId="256"/>
            <ac:grpSpMk id="10" creationId="{5A5F787B-1898-4754-B07F-ABBA3A4EEDFA}"/>
          </ac:grpSpMkLst>
        </pc:grpChg>
        <pc:grpChg chg="add mod">
          <ac:chgData name="CAMILA OSPINA AYALA" userId="78f2fe8b-a352-4d21-8a73-8c582c191c8b" providerId="ADAL" clId="{CC91BA5C-4D86-443C-A7CF-3306F6998EB7}" dt="2022-03-02T17:40:15.116" v="133" actId="164"/>
          <ac:grpSpMkLst>
            <pc:docMk/>
            <pc:sldMk cId="3513509246" sldId="256"/>
            <ac:grpSpMk id="12" creationId="{86A46DDF-3DFD-4262-8A9D-69DCB4AC9559}"/>
          </ac:grpSpMkLst>
        </pc:grpChg>
        <pc:grpChg chg="add mod">
          <ac:chgData name="CAMILA OSPINA AYALA" userId="78f2fe8b-a352-4d21-8a73-8c582c191c8b" providerId="ADAL" clId="{CC91BA5C-4D86-443C-A7CF-3306F6998EB7}" dt="2022-03-02T17:41:21.055" v="149" actId="164"/>
          <ac:grpSpMkLst>
            <pc:docMk/>
            <pc:sldMk cId="3513509246" sldId="256"/>
            <ac:grpSpMk id="13" creationId="{EF3BA452-1BB3-40B4-B39D-191449E392F2}"/>
          </ac:grpSpMkLst>
        </pc:grpChg>
        <pc:grpChg chg="mod">
          <ac:chgData name="CAMILA OSPINA AYALA" userId="78f2fe8b-a352-4d21-8a73-8c582c191c8b" providerId="ADAL" clId="{CC91BA5C-4D86-443C-A7CF-3306F6998EB7}" dt="2022-03-02T11:43:28.770" v="0" actId="165"/>
          <ac:grpSpMkLst>
            <pc:docMk/>
            <pc:sldMk cId="3513509246" sldId="256"/>
            <ac:grpSpMk id="15" creationId="{7E83C65F-6016-4224-B46D-4B3AC52081C9}"/>
          </ac:grpSpMkLst>
        </pc:grpChg>
        <pc:grpChg chg="del mod topLvl">
          <ac:chgData name="CAMILA OSPINA AYALA" userId="78f2fe8b-a352-4d21-8a73-8c582c191c8b" providerId="ADAL" clId="{CC91BA5C-4D86-443C-A7CF-3306F6998EB7}" dt="2022-03-02T17:35:03.185" v="91" actId="478"/>
          <ac:grpSpMkLst>
            <pc:docMk/>
            <pc:sldMk cId="3513509246" sldId="256"/>
            <ac:grpSpMk id="16" creationId="{5BD62117-51CC-49FD-9B14-D0BD3D7E5606}"/>
          </ac:grpSpMkLst>
        </pc:grpChg>
        <pc:grpChg chg="add mod">
          <ac:chgData name="CAMILA OSPINA AYALA" userId="78f2fe8b-a352-4d21-8a73-8c582c191c8b" providerId="ADAL" clId="{CC91BA5C-4D86-443C-A7CF-3306F6998EB7}" dt="2022-03-02T17:35:12.800" v="96" actId="14100"/>
          <ac:grpSpMkLst>
            <pc:docMk/>
            <pc:sldMk cId="3513509246" sldId="256"/>
            <ac:grpSpMk id="49" creationId="{21D9533D-844D-49D2-B61F-D9A33798CECB}"/>
          </ac:grpSpMkLst>
        </pc:grpChg>
        <pc:grpChg chg="mod">
          <ac:chgData name="CAMILA OSPINA AYALA" userId="78f2fe8b-a352-4d21-8a73-8c582c191c8b" providerId="ADAL" clId="{CC91BA5C-4D86-443C-A7CF-3306F6998EB7}" dt="2022-03-02T17:35:03.571" v="92"/>
          <ac:grpSpMkLst>
            <pc:docMk/>
            <pc:sldMk cId="3513509246" sldId="256"/>
            <ac:grpSpMk id="50" creationId="{DA3C5A63-5608-497A-A5A8-6BB90B7A9947}"/>
          </ac:grpSpMkLst>
        </pc:grpChg>
        <pc:grpChg chg="mod">
          <ac:chgData name="CAMILA OSPINA AYALA" userId="78f2fe8b-a352-4d21-8a73-8c582c191c8b" providerId="ADAL" clId="{CC91BA5C-4D86-443C-A7CF-3306F6998EB7}" dt="2022-03-02T17:35:03.571" v="92"/>
          <ac:grpSpMkLst>
            <pc:docMk/>
            <pc:sldMk cId="3513509246" sldId="256"/>
            <ac:grpSpMk id="54" creationId="{FE652C29-CB5C-434E-BC93-41A15848B128}"/>
          </ac:grpSpMkLst>
        </pc:grpChg>
        <pc:grpChg chg="add mod ord">
          <ac:chgData name="CAMILA OSPINA AYALA" userId="78f2fe8b-a352-4d21-8a73-8c582c191c8b" providerId="ADAL" clId="{CC91BA5C-4D86-443C-A7CF-3306F6998EB7}" dt="2022-03-02T18:15:27.412" v="154" actId="167"/>
          <ac:grpSpMkLst>
            <pc:docMk/>
            <pc:sldMk cId="3513509246" sldId="256"/>
            <ac:grpSpMk id="68" creationId="{B718D4B1-6120-43FA-A5BD-65AD5B22AD97}"/>
          </ac:grpSpMkLst>
        </pc:grpChg>
        <pc:grpChg chg="add mod">
          <ac:chgData name="CAMILA OSPINA AYALA" userId="78f2fe8b-a352-4d21-8a73-8c582c191c8b" providerId="ADAL" clId="{CC91BA5C-4D86-443C-A7CF-3306F6998EB7}" dt="2022-03-02T17:54:55.830" v="151" actId="164"/>
          <ac:grpSpMkLst>
            <pc:docMk/>
            <pc:sldMk cId="3513509246" sldId="256"/>
            <ac:grpSpMk id="69" creationId="{4E38DB9F-8752-45BA-8ECD-56850A61132E}"/>
          </ac:grpSpMkLst>
        </pc:grpChg>
        <pc:grpChg chg="add mod ord">
          <ac:chgData name="CAMILA OSPINA AYALA" userId="78f2fe8b-a352-4d21-8a73-8c582c191c8b" providerId="ADAL" clId="{CC91BA5C-4D86-443C-A7CF-3306F6998EB7}" dt="2022-03-02T18:15:25.563" v="153" actId="167"/>
          <ac:grpSpMkLst>
            <pc:docMk/>
            <pc:sldMk cId="3513509246" sldId="256"/>
            <ac:grpSpMk id="70" creationId="{8BF139BC-B4C3-42D0-80D4-3A1D2A0BB406}"/>
          </ac:grpSpMkLst>
        </pc:grpChg>
        <pc:picChg chg="mod">
          <ac:chgData name="CAMILA OSPINA AYALA" userId="78f2fe8b-a352-4d21-8a73-8c582c191c8b" providerId="ADAL" clId="{CC91BA5C-4D86-443C-A7CF-3306F6998EB7}" dt="2022-03-02T11:43:28.770" v="0" actId="165"/>
          <ac:picMkLst>
            <pc:docMk/>
            <pc:sldMk cId="3513509246" sldId="256"/>
            <ac:picMk id="3" creationId="{2748FDED-478B-4CD4-B3DF-3EB6DA924E4F}"/>
          </ac:picMkLst>
        </pc:picChg>
        <pc:picChg chg="add del mod">
          <ac:chgData name="CAMILA OSPINA AYALA" userId="78f2fe8b-a352-4d21-8a73-8c582c191c8b" providerId="ADAL" clId="{CC91BA5C-4D86-443C-A7CF-3306F6998EB7}" dt="2022-03-02T17:26:39.555" v="67" actId="931"/>
          <ac:picMkLst>
            <pc:docMk/>
            <pc:sldMk cId="3513509246" sldId="256"/>
            <ac:picMk id="4" creationId="{531E26B2-83FE-4181-A609-F58A774A5F7E}"/>
          </ac:picMkLst>
        </pc:picChg>
        <pc:picChg chg="add del mod modCrop">
          <ac:chgData name="CAMILA OSPINA AYALA" userId="78f2fe8b-a352-4d21-8a73-8c582c191c8b" providerId="ADAL" clId="{CC91BA5C-4D86-443C-A7CF-3306F6998EB7}" dt="2022-03-02T17:26:38.620" v="65" actId="931"/>
          <ac:picMkLst>
            <pc:docMk/>
            <pc:sldMk cId="3513509246" sldId="256"/>
            <ac:picMk id="6" creationId="{359BB996-2419-4D09-B428-C2744B82D268}"/>
          </ac:picMkLst>
        </pc:picChg>
        <pc:picChg chg="del mod topLvl">
          <ac:chgData name="CAMILA OSPINA AYALA" userId="78f2fe8b-a352-4d21-8a73-8c582c191c8b" providerId="ADAL" clId="{CC91BA5C-4D86-443C-A7CF-3306F6998EB7}" dt="2022-03-02T11:43:32.316" v="1" actId="478"/>
          <ac:picMkLst>
            <pc:docMk/>
            <pc:sldMk cId="3513509246" sldId="256"/>
            <ac:picMk id="6" creationId="{E55A6CA6-9A26-4290-AD17-4B3C816ECF4F}"/>
          </ac:picMkLst>
        </pc:picChg>
        <pc:picChg chg="add mod">
          <ac:chgData name="CAMILA OSPINA AYALA" userId="78f2fe8b-a352-4d21-8a73-8c582c191c8b" providerId="ADAL" clId="{CC91BA5C-4D86-443C-A7CF-3306F6998EB7}" dt="2022-03-02T17:40:19.623" v="134" actId="164"/>
          <ac:picMkLst>
            <pc:docMk/>
            <pc:sldMk cId="3513509246" sldId="256"/>
            <ac:picMk id="9" creationId="{ACF0F0EA-961F-40DC-A761-A387CC54E838}"/>
          </ac:picMkLst>
        </pc:picChg>
        <pc:picChg chg="add del mod">
          <ac:chgData name="CAMILA OSPINA AYALA" userId="78f2fe8b-a352-4d21-8a73-8c582c191c8b" providerId="ADAL" clId="{CC91BA5C-4D86-443C-A7CF-3306F6998EB7}" dt="2022-03-02T17:39:58.929" v="130" actId="931"/>
          <ac:picMkLst>
            <pc:docMk/>
            <pc:sldMk cId="3513509246" sldId="256"/>
            <ac:picMk id="11" creationId="{FB8BA1C9-7AE6-4477-80AD-68511F43996B}"/>
          </ac:picMkLst>
        </pc:picChg>
        <pc:picChg chg="mod">
          <ac:chgData name="CAMILA OSPINA AYALA" userId="78f2fe8b-a352-4d21-8a73-8c582c191c8b" providerId="ADAL" clId="{CC91BA5C-4D86-443C-A7CF-3306F6998EB7}" dt="2022-03-02T11:43:28.770" v="0" actId="165"/>
          <ac:picMkLst>
            <pc:docMk/>
            <pc:sldMk cId="3513509246" sldId="256"/>
            <ac:picMk id="18" creationId="{5E2E3BE4-D8DF-45CE-80E8-69E01C751179}"/>
          </ac:picMkLst>
        </pc:picChg>
        <pc:picChg chg="mod">
          <ac:chgData name="CAMILA OSPINA AYALA" userId="78f2fe8b-a352-4d21-8a73-8c582c191c8b" providerId="ADAL" clId="{CC91BA5C-4D86-443C-A7CF-3306F6998EB7}" dt="2022-03-02T11:43:28.770" v="0" actId="165"/>
          <ac:picMkLst>
            <pc:docMk/>
            <pc:sldMk cId="3513509246" sldId="256"/>
            <ac:picMk id="20" creationId="{D2B966CF-BD00-4476-8C77-EE159EC54D2D}"/>
          </ac:picMkLst>
        </pc:picChg>
        <pc:picChg chg="mod">
          <ac:chgData name="CAMILA OSPINA AYALA" userId="78f2fe8b-a352-4d21-8a73-8c582c191c8b" providerId="ADAL" clId="{CC91BA5C-4D86-443C-A7CF-3306F6998EB7}" dt="2022-03-02T11:43:28.770" v="0" actId="165"/>
          <ac:picMkLst>
            <pc:docMk/>
            <pc:sldMk cId="3513509246" sldId="256"/>
            <ac:picMk id="22" creationId="{36557F51-4591-406D-A74B-AA0F86974730}"/>
          </ac:picMkLst>
        </pc:picChg>
        <pc:picChg chg="mod">
          <ac:chgData name="CAMILA OSPINA AYALA" userId="78f2fe8b-a352-4d21-8a73-8c582c191c8b" providerId="ADAL" clId="{CC91BA5C-4D86-443C-A7CF-3306F6998EB7}" dt="2022-03-02T11:43:28.770" v="0" actId="165"/>
          <ac:picMkLst>
            <pc:docMk/>
            <pc:sldMk cId="3513509246" sldId="256"/>
            <ac:picMk id="24" creationId="{53327AEA-8B5E-4FB8-94DB-CA62964753AB}"/>
          </ac:picMkLst>
        </pc:picChg>
        <pc:picChg chg="del mod topLvl">
          <ac:chgData name="CAMILA OSPINA AYALA" userId="78f2fe8b-a352-4d21-8a73-8c582c191c8b" providerId="ADAL" clId="{CC91BA5C-4D86-443C-A7CF-3306F6998EB7}" dt="2022-03-02T11:43:55.364" v="7" actId="478"/>
          <ac:picMkLst>
            <pc:docMk/>
            <pc:sldMk cId="3513509246" sldId="256"/>
            <ac:picMk id="36" creationId="{C3CE8CD4-2A9C-4FBB-87C5-0BB7522E4DDC}"/>
          </ac:picMkLst>
        </pc:picChg>
        <pc:picChg chg="add mod ord modCrop">
          <ac:chgData name="CAMILA OSPINA AYALA" userId="78f2fe8b-a352-4d21-8a73-8c582c191c8b" providerId="ADAL" clId="{CC91BA5C-4D86-443C-A7CF-3306F6998EB7}" dt="2022-03-02T17:28:08.696" v="85" actId="164"/>
          <ac:picMkLst>
            <pc:docMk/>
            <pc:sldMk cId="3513509246" sldId="256"/>
            <ac:picMk id="38" creationId="{9259ACB8-1BC1-4E3D-AA8A-1DC4C5C97CF3}"/>
          </ac:picMkLst>
        </pc:picChg>
        <pc:picChg chg="add mod ord modCrop">
          <ac:chgData name="CAMILA OSPINA AYALA" userId="78f2fe8b-a352-4d21-8a73-8c582c191c8b" providerId="ADAL" clId="{CC91BA5C-4D86-443C-A7CF-3306F6998EB7}" dt="2022-03-02T17:41:21.055" v="149" actId="164"/>
          <ac:picMkLst>
            <pc:docMk/>
            <pc:sldMk cId="3513509246" sldId="256"/>
            <ac:picMk id="39" creationId="{401EE87B-5F5C-4640-9CCB-754B9688B55E}"/>
          </ac:picMkLst>
        </pc:picChg>
        <pc:picChg chg="mod">
          <ac:chgData name="CAMILA OSPINA AYALA" userId="78f2fe8b-a352-4d21-8a73-8c582c191c8b" providerId="ADAL" clId="{CC91BA5C-4D86-443C-A7CF-3306F6998EB7}" dt="2022-03-02T17:35:03.571" v="92"/>
          <ac:picMkLst>
            <pc:docMk/>
            <pc:sldMk cId="3513509246" sldId="256"/>
            <ac:picMk id="53" creationId="{D64CEBC3-CB68-40E3-B2C1-A7FCFA7E1717}"/>
          </ac:picMkLst>
        </pc:picChg>
        <pc:picChg chg="mod">
          <ac:chgData name="CAMILA OSPINA AYALA" userId="78f2fe8b-a352-4d21-8a73-8c582c191c8b" providerId="ADAL" clId="{CC91BA5C-4D86-443C-A7CF-3306F6998EB7}" dt="2022-03-02T17:35:03.571" v="92"/>
          <ac:picMkLst>
            <pc:docMk/>
            <pc:sldMk cId="3513509246" sldId="256"/>
            <ac:picMk id="55" creationId="{42CD3CF8-DC2E-4C8D-B735-39EA91ABC61C}"/>
          </ac:picMkLst>
        </pc:picChg>
        <pc:picChg chg="mod">
          <ac:chgData name="CAMILA OSPINA AYALA" userId="78f2fe8b-a352-4d21-8a73-8c582c191c8b" providerId="ADAL" clId="{CC91BA5C-4D86-443C-A7CF-3306F6998EB7}" dt="2022-03-02T17:35:03.571" v="92"/>
          <ac:picMkLst>
            <pc:docMk/>
            <pc:sldMk cId="3513509246" sldId="256"/>
            <ac:picMk id="56" creationId="{5271A8C7-1E34-4510-B9A9-CA7B116865B9}"/>
          </ac:picMkLst>
        </pc:picChg>
        <pc:picChg chg="mod">
          <ac:chgData name="CAMILA OSPINA AYALA" userId="78f2fe8b-a352-4d21-8a73-8c582c191c8b" providerId="ADAL" clId="{CC91BA5C-4D86-443C-A7CF-3306F6998EB7}" dt="2022-03-02T17:35:03.571" v="92"/>
          <ac:picMkLst>
            <pc:docMk/>
            <pc:sldMk cId="3513509246" sldId="256"/>
            <ac:picMk id="57" creationId="{47BBC2D1-35EB-4A60-A490-AE9ACB0D3C58}"/>
          </ac:picMkLst>
        </pc:picChg>
        <pc:picChg chg="mod">
          <ac:chgData name="CAMILA OSPINA AYALA" userId="78f2fe8b-a352-4d21-8a73-8c582c191c8b" providerId="ADAL" clId="{CC91BA5C-4D86-443C-A7CF-3306F6998EB7}" dt="2022-03-02T17:35:03.571" v="92"/>
          <ac:picMkLst>
            <pc:docMk/>
            <pc:sldMk cId="3513509246" sldId="256"/>
            <ac:picMk id="62" creationId="{B156768B-6BA2-4123-AB3C-C16CCD6D01B1}"/>
          </ac:picMkLst>
        </pc:picChg>
        <pc:picChg chg="add mod ord">
          <ac:chgData name="CAMILA OSPINA AYALA" userId="78f2fe8b-a352-4d21-8a73-8c582c191c8b" providerId="ADAL" clId="{CC91BA5C-4D86-443C-A7CF-3306F6998EB7}" dt="2022-03-02T17:41:21.055" v="149" actId="164"/>
          <ac:picMkLst>
            <pc:docMk/>
            <pc:sldMk cId="3513509246" sldId="256"/>
            <ac:picMk id="66" creationId="{3C0B9047-739F-490E-8616-A342857A3B27}"/>
          </ac:picMkLst>
        </pc:picChg>
      </pc:sldChg>
    </pc:docChg>
  </pc:docChgLst>
  <pc:docChgLst>
    <pc:chgData name="CAMILA OSPINA AYALA" userId="78f2fe8b-a352-4d21-8a73-8c582c191c8b" providerId="ADAL" clId="{187911B5-20BD-4C8F-B5D0-28267442506B}"/>
    <pc:docChg chg="undo custSel modSld">
      <pc:chgData name="CAMILA OSPINA AYALA" userId="78f2fe8b-a352-4d21-8a73-8c582c191c8b" providerId="ADAL" clId="{187911B5-20BD-4C8F-B5D0-28267442506B}" dt="2022-02-24T21:33:26.034" v="326" actId="165"/>
      <pc:docMkLst>
        <pc:docMk/>
      </pc:docMkLst>
      <pc:sldChg chg="addSp delSp modSp mod">
        <pc:chgData name="CAMILA OSPINA AYALA" userId="78f2fe8b-a352-4d21-8a73-8c582c191c8b" providerId="ADAL" clId="{187911B5-20BD-4C8F-B5D0-28267442506B}" dt="2022-02-24T21:33:26.034" v="326" actId="165"/>
        <pc:sldMkLst>
          <pc:docMk/>
          <pc:sldMk cId="3513509246" sldId="256"/>
        </pc:sldMkLst>
        <pc:spChg chg="mod">
          <ac:chgData name="CAMILA OSPINA AYALA" userId="78f2fe8b-a352-4d21-8a73-8c582c191c8b" providerId="ADAL" clId="{187911B5-20BD-4C8F-B5D0-28267442506B}" dt="2022-02-24T21:23:24.298" v="14" actId="1076"/>
          <ac:spMkLst>
            <pc:docMk/>
            <pc:sldMk cId="3513509246" sldId="256"/>
            <ac:spMk id="14" creationId="{559545BB-4BA5-4679-B338-FBC782E75B16}"/>
          </ac:spMkLst>
        </pc:spChg>
        <pc:spChg chg="add del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19" creationId="{AC4C3DC5-C950-4469-B152-4E43DE1B5036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1" creationId="{1CA3E8AA-CACE-4939-89EE-2E2C569FA7D2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3" creationId="{2223FC15-4D9E-4B6E-8A58-F6F5B19D2659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5" creationId="{599088B4-5A7A-4909-B659-A569413595EE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6" creationId="{000E1D5E-750D-4A86-887D-B8AE804C8B3B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7" creationId="{EDE3F7CC-9264-4DB8-90A9-8EF5F9D9F236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8" creationId="{4932058E-A20F-4F48-953C-EDBFFCE96125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9" creationId="{5751DFF6-0BE3-49DA-9152-418AC0EC2206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34" creationId="{0CE25098-89F7-4813-B544-78663C75256E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35" creationId="{2843D0DD-7137-4E59-8F50-E9A10B68152C}"/>
          </ac:spMkLst>
        </pc:spChg>
        <pc:grpChg chg="add del mod">
          <ac:chgData name="CAMILA OSPINA AYALA" userId="78f2fe8b-a352-4d21-8a73-8c582c191c8b" providerId="ADAL" clId="{187911B5-20BD-4C8F-B5D0-28267442506B}" dt="2022-02-24T21:30:56.916" v="282" actId="165"/>
          <ac:grpSpMkLst>
            <pc:docMk/>
            <pc:sldMk cId="3513509246" sldId="256"/>
            <ac:grpSpMk id="5" creationId="{006DE612-4C2B-4E1B-B82E-F339281C75D5}"/>
          </ac:grpSpMkLst>
        </pc:grpChg>
        <pc:grpChg chg="add del mod">
          <ac:chgData name="CAMILA OSPINA AYALA" userId="78f2fe8b-a352-4d21-8a73-8c582c191c8b" providerId="ADAL" clId="{187911B5-20BD-4C8F-B5D0-28267442506B}" dt="2022-02-24T21:32:43.805" v="316" actId="165"/>
          <ac:grpSpMkLst>
            <pc:docMk/>
            <pc:sldMk cId="3513509246" sldId="256"/>
            <ac:grpSpMk id="6" creationId="{A0A96CC2-E922-4833-B114-2553F37C9A33}"/>
          </ac:grpSpMkLst>
        </pc:grpChg>
        <pc:grpChg chg="add del mod">
          <ac:chgData name="CAMILA OSPINA AYALA" userId="78f2fe8b-a352-4d21-8a73-8c582c191c8b" providerId="ADAL" clId="{187911B5-20BD-4C8F-B5D0-28267442506B}" dt="2022-02-24T21:33:26.034" v="326" actId="165"/>
          <ac:grpSpMkLst>
            <pc:docMk/>
            <pc:sldMk cId="3513509246" sldId="256"/>
            <ac:grpSpMk id="7" creationId="{70B8AE92-9F7E-43B5-9888-4C997963DB39}"/>
          </ac:grpSpMkLst>
        </pc:grpChg>
        <pc:picChg chg="add mod modCrop">
          <ac:chgData name="CAMILA OSPINA AYALA" userId="78f2fe8b-a352-4d21-8a73-8c582c191c8b" providerId="ADAL" clId="{187911B5-20BD-4C8F-B5D0-28267442506B}" dt="2022-02-24T21:32:03.241" v="310" actId="1076"/>
          <ac:picMkLst>
            <pc:docMk/>
            <pc:sldMk cId="3513509246" sldId="256"/>
            <ac:picMk id="4" creationId="{E927BDED-F7F8-4118-95A6-5DD1716F8A88}"/>
          </ac:picMkLst>
        </pc:picChg>
        <pc:picChg chg="del">
          <ac:chgData name="CAMILA OSPINA AYALA" userId="78f2fe8b-a352-4d21-8a73-8c582c191c8b" providerId="ADAL" clId="{187911B5-20BD-4C8F-B5D0-28267442506B}" dt="2022-02-24T21:21:00.561" v="1" actId="478"/>
          <ac:picMkLst>
            <pc:docMk/>
            <pc:sldMk cId="3513509246" sldId="256"/>
            <ac:picMk id="13" creationId="{3528E06E-326A-4332-977C-BC054873EE2B}"/>
          </ac:picMkLst>
        </pc:picChg>
        <pc:picChg chg="add del mod modCrop">
          <ac:chgData name="CAMILA OSPINA AYALA" userId="78f2fe8b-a352-4d21-8a73-8c582c191c8b" providerId="ADAL" clId="{187911B5-20BD-4C8F-B5D0-28267442506B}" dt="2022-02-24T21:21:40.512" v="13" actId="478"/>
          <ac:picMkLst>
            <pc:docMk/>
            <pc:sldMk cId="3513509246" sldId="256"/>
            <ac:picMk id="17" creationId="{618A0970-9F8E-486E-9464-E7FFFE0AADF9}"/>
          </ac:picMkLst>
        </pc:picChg>
      </pc:sldChg>
    </pc:docChg>
  </pc:docChgLst>
  <pc:docChgLst>
    <pc:chgData name="CAMILA OSPINA AYALA" userId="78f2fe8b-a352-4d21-8a73-8c582c191c8b" providerId="ADAL" clId="{D3359856-0D9B-4CD0-9A7F-00D1D50B7661}"/>
    <pc:docChg chg="modSld">
      <pc:chgData name="CAMILA OSPINA AYALA" userId="78f2fe8b-a352-4d21-8a73-8c582c191c8b" providerId="ADAL" clId="{D3359856-0D9B-4CD0-9A7F-00D1D50B7661}" dt="2022-03-05T17:53:58.636" v="3" actId="14100"/>
      <pc:docMkLst>
        <pc:docMk/>
      </pc:docMkLst>
      <pc:sldChg chg="modSp mod">
        <pc:chgData name="CAMILA OSPINA AYALA" userId="78f2fe8b-a352-4d21-8a73-8c582c191c8b" providerId="ADAL" clId="{D3359856-0D9B-4CD0-9A7F-00D1D50B7661}" dt="2022-03-05T17:53:58.636" v="3" actId="14100"/>
        <pc:sldMkLst>
          <pc:docMk/>
          <pc:sldMk cId="3513509246" sldId="256"/>
        </pc:sldMkLst>
        <pc:spChg chg="mod">
          <ac:chgData name="CAMILA OSPINA AYALA" userId="78f2fe8b-a352-4d21-8a73-8c582c191c8b" providerId="ADAL" clId="{D3359856-0D9B-4CD0-9A7F-00D1D50B7661}" dt="2022-03-05T17:53:58.636" v="3" actId="14100"/>
          <ac:spMkLst>
            <pc:docMk/>
            <pc:sldMk cId="3513509246" sldId="256"/>
            <ac:spMk id="67" creationId="{67CD50A1-6B7A-447E-9A01-26CB9390E2BE}"/>
          </ac:spMkLst>
        </pc:spChg>
      </pc:sldChg>
    </pc:docChg>
  </pc:docChgLst>
  <pc:docChgLst>
    <pc:chgData name="CAMILA OSPINA AYALA" userId="78f2fe8b-a352-4d21-8a73-8c582c191c8b" providerId="ADAL" clId="{045262AA-3CDD-44FA-8FDD-B4A21D74F4F7}"/>
    <pc:docChg chg="undo custSel modSld">
      <pc:chgData name="CAMILA OSPINA AYALA" userId="78f2fe8b-a352-4d21-8a73-8c582c191c8b" providerId="ADAL" clId="{045262AA-3CDD-44FA-8FDD-B4A21D74F4F7}" dt="2022-03-02T10:57:18.595" v="76" actId="14100"/>
      <pc:docMkLst>
        <pc:docMk/>
      </pc:docMkLst>
      <pc:sldChg chg="addSp delSp modSp mod">
        <pc:chgData name="CAMILA OSPINA AYALA" userId="78f2fe8b-a352-4d21-8a73-8c582c191c8b" providerId="ADAL" clId="{045262AA-3CDD-44FA-8FDD-B4A21D74F4F7}" dt="2022-03-02T10:57:18.595" v="76" actId="14100"/>
        <pc:sldMkLst>
          <pc:docMk/>
          <pc:sldMk cId="3513509246" sldId="256"/>
        </pc:sldMkLst>
        <pc:spChg chg="add del mod">
          <ac:chgData name="CAMILA OSPINA AYALA" userId="78f2fe8b-a352-4d21-8a73-8c582c191c8b" providerId="ADAL" clId="{045262AA-3CDD-44FA-8FDD-B4A21D74F4F7}" dt="2022-03-02T10:57:14.238" v="75"/>
          <ac:spMkLst>
            <pc:docMk/>
            <pc:sldMk cId="3513509246" sldId="256"/>
            <ac:spMk id="5" creationId="{0E538BAC-48E6-4FB4-BA4E-21F8528DE263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14" creationId="{559545BB-4BA5-4679-B338-FBC782E75B16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19" creationId="{AC4C3DC5-C950-4469-B152-4E43DE1B5036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1" creationId="{1CA3E8AA-CACE-4939-89EE-2E2C569FA7D2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3" creationId="{2223FC15-4D9E-4B6E-8A58-F6F5B19D2659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5" creationId="{599088B4-5A7A-4909-B659-A569413595EE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6" creationId="{000E1D5E-750D-4A86-887D-B8AE804C8B3B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7" creationId="{EDE3F7CC-9264-4DB8-90A9-8EF5F9D9F236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8" creationId="{4932058E-A20F-4F48-953C-EDBFFCE96125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9" creationId="{5751DFF6-0BE3-49DA-9152-418AC0EC2206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30" creationId="{F3C4E3DD-1D10-4D5A-81CD-763ECE650A65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31" creationId="{07AE9398-1881-469F-951D-29ADA2B178B6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32" creationId="{F663FA82-1B76-4B5E-939C-AED05F0BEF2C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33" creationId="{44C6A6F1-68BE-4290-B0AA-CE94068E701A}"/>
          </ac:spMkLst>
        </pc:spChg>
        <pc:spChg chg="mod">
          <ac:chgData name="CAMILA OSPINA AYALA" userId="78f2fe8b-a352-4d21-8a73-8c582c191c8b" providerId="ADAL" clId="{045262AA-3CDD-44FA-8FDD-B4A21D74F4F7}" dt="2022-03-02T10:56:16.443" v="61" actId="14100"/>
          <ac:spMkLst>
            <pc:docMk/>
            <pc:sldMk cId="3513509246" sldId="256"/>
            <ac:spMk id="34" creationId="{0CE25098-89F7-4813-B544-78663C75256E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35" creationId="{2843D0DD-7137-4E59-8F50-E9A10B68152C}"/>
          </ac:spMkLst>
        </pc:spChg>
        <pc:grpChg chg="add mod topLvl">
          <ac:chgData name="CAMILA OSPINA AYALA" userId="78f2fe8b-a352-4d21-8a73-8c582c191c8b" providerId="ADAL" clId="{045262AA-3CDD-44FA-8FDD-B4A21D74F4F7}" dt="2022-03-02T10:55:55.798" v="56" actId="1076"/>
          <ac:grpSpMkLst>
            <pc:docMk/>
            <pc:sldMk cId="3513509246" sldId="256"/>
            <ac:grpSpMk id="2" creationId="{6927146B-06B4-41B4-AD3D-AA0F2FB64A1B}"/>
          </ac:grpSpMkLst>
        </pc:grpChg>
        <pc:grpChg chg="add del mod">
          <ac:chgData name="CAMILA OSPINA AYALA" userId="78f2fe8b-a352-4d21-8a73-8c582c191c8b" providerId="ADAL" clId="{045262AA-3CDD-44FA-8FDD-B4A21D74F4F7}" dt="2022-03-02T10:55:49.850" v="55" actId="165"/>
          <ac:grpSpMkLst>
            <pc:docMk/>
            <pc:sldMk cId="3513509246" sldId="256"/>
            <ac:grpSpMk id="4" creationId="{DC2369D1-6D56-482A-ADFF-DEBD9D185D54}"/>
          </ac:grpSpMkLst>
        </pc:grpChg>
        <pc:grpChg chg="mod">
          <ac:chgData name="CAMILA OSPINA AYALA" userId="78f2fe8b-a352-4d21-8a73-8c582c191c8b" providerId="ADAL" clId="{045262AA-3CDD-44FA-8FDD-B4A21D74F4F7}" dt="2022-03-02T10:55:49.850" v="55" actId="165"/>
          <ac:grpSpMkLst>
            <pc:docMk/>
            <pc:sldMk cId="3513509246" sldId="256"/>
            <ac:grpSpMk id="15" creationId="{7E83C65F-6016-4224-B46D-4B3AC52081C9}"/>
          </ac:grpSpMkLst>
        </pc:grpChg>
        <pc:grpChg chg="mod topLvl">
          <ac:chgData name="CAMILA OSPINA AYALA" userId="78f2fe8b-a352-4d21-8a73-8c582c191c8b" providerId="ADAL" clId="{045262AA-3CDD-44FA-8FDD-B4A21D74F4F7}" dt="2022-03-02T10:56:29.687" v="64" actId="1076"/>
          <ac:grpSpMkLst>
            <pc:docMk/>
            <pc:sldMk cId="3513509246" sldId="256"/>
            <ac:grpSpMk id="16" creationId="{5BD62117-51CC-49FD-9B14-D0BD3D7E5606}"/>
          </ac:grpSpMkLst>
        </pc:grp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3" creationId="{2748FDED-478B-4CD4-B3DF-3EB6DA924E4F}"/>
          </ac:picMkLst>
        </pc:picChg>
        <pc:picChg chg="del mod">
          <ac:chgData name="CAMILA OSPINA AYALA" userId="78f2fe8b-a352-4d21-8a73-8c582c191c8b" providerId="ADAL" clId="{045262AA-3CDD-44FA-8FDD-B4A21D74F4F7}" dt="2022-03-02T10:49:58.917" v="1" actId="478"/>
          <ac:picMkLst>
            <pc:docMk/>
            <pc:sldMk cId="3513509246" sldId="256"/>
            <ac:picMk id="7" creationId="{87477C72-F0F7-4B37-A057-6FF4500B3AC3}"/>
          </ac:picMkLst>
        </pc:pic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18" creationId="{5E2E3BE4-D8DF-45CE-80E8-69E01C751179}"/>
          </ac:picMkLst>
        </pc:pic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20" creationId="{D2B966CF-BD00-4476-8C77-EE159EC54D2D}"/>
          </ac:picMkLst>
        </pc:pic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22" creationId="{36557F51-4591-406D-A74B-AA0F86974730}"/>
          </ac:picMkLst>
        </pc:pic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24" creationId="{53327AEA-8B5E-4FB8-94DB-CA62964753AB}"/>
          </ac:picMkLst>
        </pc:picChg>
        <pc:picChg chg="add mod topLvl modCrop">
          <ac:chgData name="CAMILA OSPINA AYALA" userId="78f2fe8b-a352-4d21-8a73-8c582c191c8b" providerId="ADAL" clId="{045262AA-3CDD-44FA-8FDD-B4A21D74F4F7}" dt="2022-03-02T10:55:55.798" v="56" actId="1076"/>
          <ac:picMkLst>
            <pc:docMk/>
            <pc:sldMk cId="3513509246" sldId="256"/>
            <ac:picMk id="36" creationId="{240CFFA7-6776-4BB4-A10E-110E4608601C}"/>
          </ac:picMkLst>
        </pc:picChg>
        <pc:picChg chg="add mod ord topLvl modCrop">
          <ac:chgData name="CAMILA OSPINA AYALA" userId="78f2fe8b-a352-4d21-8a73-8c582c191c8b" providerId="ADAL" clId="{045262AA-3CDD-44FA-8FDD-B4A21D74F4F7}" dt="2022-03-02T10:57:18.595" v="76" actId="14100"/>
          <ac:picMkLst>
            <pc:docMk/>
            <pc:sldMk cId="3513509246" sldId="256"/>
            <ac:picMk id="37" creationId="{5E6B721C-733D-4DDF-BFB0-4D1DDB586641}"/>
          </ac:picMkLst>
        </pc:picChg>
        <pc:picChg chg="add del mod">
          <ac:chgData name="CAMILA OSPINA AYALA" userId="78f2fe8b-a352-4d21-8a73-8c582c191c8b" providerId="ADAL" clId="{045262AA-3CDD-44FA-8FDD-B4A21D74F4F7}" dt="2022-03-02T10:56:38.460" v="66"/>
          <ac:picMkLst>
            <pc:docMk/>
            <pc:sldMk cId="3513509246" sldId="256"/>
            <ac:picMk id="38" creationId="{439D82FD-8D7E-4AFD-971F-1AFCCD8BEE78}"/>
          </ac:picMkLst>
        </pc:picChg>
      </pc:sldChg>
    </pc:docChg>
  </pc:docChgLst>
  <pc:docChgLst>
    <pc:chgData name="CAMILA OSPINA AYALA" userId="78f2fe8b-a352-4d21-8a73-8c582c191c8b" providerId="ADAL" clId="{61CD1945-972D-430F-815D-84233682A485}"/>
    <pc:docChg chg="undo custSel modSld">
      <pc:chgData name="CAMILA OSPINA AYALA" userId="78f2fe8b-a352-4d21-8a73-8c582c191c8b" providerId="ADAL" clId="{61CD1945-972D-430F-815D-84233682A485}" dt="2022-03-02T11:15:09.353" v="35" actId="14100"/>
      <pc:docMkLst>
        <pc:docMk/>
      </pc:docMkLst>
      <pc:sldChg chg="addSp delSp modSp mod">
        <pc:chgData name="CAMILA OSPINA AYALA" userId="78f2fe8b-a352-4d21-8a73-8c582c191c8b" providerId="ADAL" clId="{61CD1945-972D-430F-815D-84233682A485}" dt="2022-03-02T11:15:09.353" v="35" actId="14100"/>
        <pc:sldMkLst>
          <pc:docMk/>
          <pc:sldMk cId="3513509246" sldId="256"/>
        </pc:sldMkLst>
        <pc:spChg chg="mod">
          <ac:chgData name="CAMILA OSPINA AYALA" userId="78f2fe8b-a352-4d21-8a73-8c582c191c8b" providerId="ADAL" clId="{61CD1945-972D-430F-815D-84233682A485}" dt="2022-03-02T11:14:34.024" v="27" actId="164"/>
          <ac:spMkLst>
            <pc:docMk/>
            <pc:sldMk cId="3513509246" sldId="256"/>
            <ac:spMk id="14" creationId="{559545BB-4BA5-4679-B338-FBC782E75B16}"/>
          </ac:spMkLst>
        </pc:spChg>
        <pc:spChg chg="mod">
          <ac:chgData name="CAMILA OSPINA AYALA" userId="78f2fe8b-a352-4d21-8a73-8c582c191c8b" providerId="ADAL" clId="{61CD1945-972D-430F-815D-84233682A485}" dt="2022-03-02T11:14:34.024" v="27" actId="164"/>
          <ac:spMkLst>
            <pc:docMk/>
            <pc:sldMk cId="3513509246" sldId="256"/>
            <ac:spMk id="30" creationId="{F3C4E3DD-1D10-4D5A-81CD-763ECE650A65}"/>
          </ac:spMkLst>
        </pc:spChg>
        <pc:spChg chg="mod">
          <ac:chgData name="CAMILA OSPINA AYALA" userId="78f2fe8b-a352-4d21-8a73-8c582c191c8b" providerId="ADAL" clId="{61CD1945-972D-430F-815D-84233682A485}" dt="2022-03-02T11:14:34.024" v="27" actId="164"/>
          <ac:spMkLst>
            <pc:docMk/>
            <pc:sldMk cId="3513509246" sldId="256"/>
            <ac:spMk id="31" creationId="{07AE9398-1881-469F-951D-29ADA2B178B6}"/>
          </ac:spMkLst>
        </pc:spChg>
        <pc:spChg chg="mod">
          <ac:chgData name="CAMILA OSPINA AYALA" userId="78f2fe8b-a352-4d21-8a73-8c582c191c8b" providerId="ADAL" clId="{61CD1945-972D-430F-815D-84233682A485}" dt="2022-03-02T11:14:34.024" v="27" actId="164"/>
          <ac:spMkLst>
            <pc:docMk/>
            <pc:sldMk cId="3513509246" sldId="256"/>
            <ac:spMk id="32" creationId="{F663FA82-1B76-4B5E-939C-AED05F0BEF2C}"/>
          </ac:spMkLst>
        </pc:spChg>
        <pc:spChg chg="mod">
          <ac:chgData name="CAMILA OSPINA AYALA" userId="78f2fe8b-a352-4d21-8a73-8c582c191c8b" providerId="ADAL" clId="{61CD1945-972D-430F-815D-84233682A485}" dt="2022-03-02T11:14:34.024" v="27" actId="164"/>
          <ac:spMkLst>
            <pc:docMk/>
            <pc:sldMk cId="3513509246" sldId="256"/>
            <ac:spMk id="33" creationId="{44C6A6F1-68BE-4290-B0AA-CE94068E701A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0" creationId="{D8A0D728-6EAA-49E9-9CD5-149A596A6F87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1" creationId="{2BE80D81-B761-4C85-B898-6D74DD5F18D7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2" creationId="{285A9BFB-C127-4C0B-9484-0F8D199BDC6C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3" creationId="{464D99F4-0446-4B65-84D7-EFAE58EACD2C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4" creationId="{D58ABC9F-EC28-44EA-A866-FC46858CE905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5" creationId="{B99C80FB-3AF6-4EB5-862E-56D05DB05595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6" creationId="{4A0E0C1A-A83B-423D-8DE9-86D8EC95E2A2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7" creationId="{D42535B8-9D3D-48E2-8FDA-1BA88C7BC11E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8" creationId="{B79F26A9-0111-4E0C-A74B-D1056703AECD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9" creationId="{0D2DD4E9-B5CE-4871-9EE5-340EAB09868E}"/>
          </ac:spMkLst>
        </pc:spChg>
        <pc:grpChg chg="mod">
          <ac:chgData name="CAMILA OSPINA AYALA" userId="78f2fe8b-a352-4d21-8a73-8c582c191c8b" providerId="ADAL" clId="{61CD1945-972D-430F-815D-84233682A485}" dt="2022-03-02T11:14:43.979" v="29" actId="164"/>
          <ac:grpSpMkLst>
            <pc:docMk/>
            <pc:sldMk cId="3513509246" sldId="256"/>
            <ac:grpSpMk id="2" creationId="{6927146B-06B4-41B4-AD3D-AA0F2FB64A1B}"/>
          </ac:grpSpMkLst>
        </pc:grpChg>
        <pc:grpChg chg="add mod">
          <ac:chgData name="CAMILA OSPINA AYALA" userId="78f2fe8b-a352-4d21-8a73-8c582c191c8b" providerId="ADAL" clId="{61CD1945-972D-430F-815D-84233682A485}" dt="2022-03-02T11:14:34.024" v="27" actId="164"/>
          <ac:grpSpMkLst>
            <pc:docMk/>
            <pc:sldMk cId="3513509246" sldId="256"/>
            <ac:grpSpMk id="6" creationId="{6AEC778E-AD0B-4E36-9DEA-71365BFC35D5}"/>
          </ac:grpSpMkLst>
        </pc:grpChg>
        <pc:grpChg chg="add mod">
          <ac:chgData name="CAMILA OSPINA AYALA" userId="78f2fe8b-a352-4d21-8a73-8c582c191c8b" providerId="ADAL" clId="{61CD1945-972D-430F-815D-84233682A485}" dt="2022-03-02T11:15:09.353" v="35" actId="14100"/>
          <ac:grpSpMkLst>
            <pc:docMk/>
            <pc:sldMk cId="3513509246" sldId="256"/>
            <ac:grpSpMk id="7" creationId="{E21149BA-3532-482D-8897-6DA63790DBF6}"/>
          </ac:grpSpMkLst>
        </pc:grpChg>
        <pc:grpChg chg="mod">
          <ac:chgData name="CAMILA OSPINA AYALA" userId="78f2fe8b-a352-4d21-8a73-8c582c191c8b" providerId="ADAL" clId="{61CD1945-972D-430F-815D-84233682A485}" dt="2022-03-02T11:14:34.024" v="27" actId="164"/>
          <ac:grpSpMkLst>
            <pc:docMk/>
            <pc:sldMk cId="3513509246" sldId="256"/>
            <ac:grpSpMk id="15" creationId="{7E83C65F-6016-4224-B46D-4B3AC52081C9}"/>
          </ac:grpSpMkLst>
        </pc:grpChg>
        <pc:grpChg chg="mod">
          <ac:chgData name="CAMILA OSPINA AYALA" userId="78f2fe8b-a352-4d21-8a73-8c582c191c8b" providerId="ADAL" clId="{61CD1945-972D-430F-815D-84233682A485}" dt="2022-03-02T11:14:43.979" v="29" actId="164"/>
          <ac:grpSpMkLst>
            <pc:docMk/>
            <pc:sldMk cId="3513509246" sldId="256"/>
            <ac:grpSpMk id="16" creationId="{5BD62117-51CC-49FD-9B14-D0BD3D7E5606}"/>
          </ac:grpSpMkLst>
        </pc:grpChg>
        <pc:grpChg chg="add mod">
          <ac:chgData name="CAMILA OSPINA AYALA" userId="78f2fe8b-a352-4d21-8a73-8c582c191c8b" providerId="ADAL" clId="{61CD1945-972D-430F-815D-84233682A485}" dt="2022-03-02T11:14:34.610" v="28" actId="571"/>
          <ac:grpSpMkLst>
            <pc:docMk/>
            <pc:sldMk cId="3513509246" sldId="256"/>
            <ac:grpSpMk id="39" creationId="{96D85937-DBD4-4213-924D-DBF8E7F30678}"/>
          </ac:grpSpMkLst>
        </pc:grpChg>
        <pc:picChg chg="mod">
          <ac:chgData name="CAMILA OSPINA AYALA" userId="78f2fe8b-a352-4d21-8a73-8c582c191c8b" providerId="ADAL" clId="{61CD1945-972D-430F-815D-84233682A485}" dt="2022-03-02T11:14:34.024" v="27" actId="164"/>
          <ac:picMkLst>
            <pc:docMk/>
            <pc:sldMk cId="3513509246" sldId="256"/>
            <ac:picMk id="3" creationId="{2748FDED-478B-4CD4-B3DF-3EB6DA924E4F}"/>
          </ac:picMkLst>
        </pc:picChg>
        <pc:picChg chg="add mod">
          <ac:chgData name="CAMILA OSPINA AYALA" userId="78f2fe8b-a352-4d21-8a73-8c582c191c8b" providerId="ADAL" clId="{61CD1945-972D-430F-815D-84233682A485}" dt="2022-03-02T11:14:43.979" v="29" actId="164"/>
          <ac:picMkLst>
            <pc:docMk/>
            <pc:sldMk cId="3513509246" sldId="256"/>
            <ac:picMk id="5" creationId="{66DB4737-9EAD-4970-8CF2-92916B86221E}"/>
          </ac:picMkLst>
        </pc:picChg>
        <pc:picChg chg="mod">
          <ac:chgData name="CAMILA OSPINA AYALA" userId="78f2fe8b-a352-4d21-8a73-8c582c191c8b" providerId="ADAL" clId="{61CD1945-972D-430F-815D-84233682A485}" dt="2022-03-02T11:14:34.024" v="27" actId="164"/>
          <ac:picMkLst>
            <pc:docMk/>
            <pc:sldMk cId="3513509246" sldId="256"/>
            <ac:picMk id="18" creationId="{5E2E3BE4-D8DF-45CE-80E8-69E01C751179}"/>
          </ac:picMkLst>
        </pc:picChg>
        <pc:picChg chg="mod">
          <ac:chgData name="CAMILA OSPINA AYALA" userId="78f2fe8b-a352-4d21-8a73-8c582c191c8b" providerId="ADAL" clId="{61CD1945-972D-430F-815D-84233682A485}" dt="2022-03-02T11:14:34.024" v="27" actId="164"/>
          <ac:picMkLst>
            <pc:docMk/>
            <pc:sldMk cId="3513509246" sldId="256"/>
            <ac:picMk id="20" creationId="{D2B966CF-BD00-4476-8C77-EE159EC54D2D}"/>
          </ac:picMkLst>
        </pc:picChg>
        <pc:picChg chg="mod">
          <ac:chgData name="CAMILA OSPINA AYALA" userId="78f2fe8b-a352-4d21-8a73-8c582c191c8b" providerId="ADAL" clId="{61CD1945-972D-430F-815D-84233682A485}" dt="2022-03-02T11:14:34.024" v="27" actId="164"/>
          <ac:picMkLst>
            <pc:docMk/>
            <pc:sldMk cId="3513509246" sldId="256"/>
            <ac:picMk id="22" creationId="{36557F51-4591-406D-A74B-AA0F86974730}"/>
          </ac:picMkLst>
        </pc:picChg>
        <pc:picChg chg="mod">
          <ac:chgData name="CAMILA OSPINA AYALA" userId="78f2fe8b-a352-4d21-8a73-8c582c191c8b" providerId="ADAL" clId="{61CD1945-972D-430F-815D-84233682A485}" dt="2022-03-02T11:14:34.024" v="27" actId="164"/>
          <ac:picMkLst>
            <pc:docMk/>
            <pc:sldMk cId="3513509246" sldId="256"/>
            <ac:picMk id="24" creationId="{53327AEA-8B5E-4FB8-94DB-CA62964753AB}"/>
          </ac:picMkLst>
        </pc:picChg>
        <pc:picChg chg="del mod">
          <ac:chgData name="CAMILA OSPINA AYALA" userId="78f2fe8b-a352-4d21-8a73-8c582c191c8b" providerId="ADAL" clId="{61CD1945-972D-430F-815D-84233682A485}" dt="2022-03-02T11:12:33.353" v="1" actId="478"/>
          <ac:picMkLst>
            <pc:docMk/>
            <pc:sldMk cId="3513509246" sldId="256"/>
            <ac:picMk id="36" creationId="{240CFFA7-6776-4BB4-A10E-110E4608601C}"/>
          </ac:picMkLst>
        </pc:picChg>
        <pc:picChg chg="del">
          <ac:chgData name="CAMILA OSPINA AYALA" userId="78f2fe8b-a352-4d21-8a73-8c582c191c8b" providerId="ADAL" clId="{61CD1945-972D-430F-815D-84233682A485}" dt="2022-03-02T11:13:10.018" v="12" actId="478"/>
          <ac:picMkLst>
            <pc:docMk/>
            <pc:sldMk cId="3513509246" sldId="256"/>
            <ac:picMk id="37" creationId="{5E6B721C-733D-4DDF-BFB0-4D1DDB586641}"/>
          </ac:picMkLst>
        </pc:picChg>
        <pc:picChg chg="add mod">
          <ac:chgData name="CAMILA OSPINA AYALA" userId="78f2fe8b-a352-4d21-8a73-8c582c191c8b" providerId="ADAL" clId="{61CD1945-972D-430F-815D-84233682A485}" dt="2022-03-02T11:14:43.979" v="29" actId="164"/>
          <ac:picMkLst>
            <pc:docMk/>
            <pc:sldMk cId="3513509246" sldId="256"/>
            <ac:picMk id="38" creationId="{A5C773F6-DFC6-4812-8DDD-69F6040F032A}"/>
          </ac:picMkLst>
        </pc:picChg>
      </pc:sldChg>
    </pc:docChg>
  </pc:docChgLst>
  <pc:docChgLst>
    <pc:chgData name="CAMILA OSPINA AYALA" userId="78f2fe8b-a352-4d21-8a73-8c582c191c8b" providerId="ADAL" clId="{AB7D9840-CA5B-4FFC-A813-372B7C481899}"/>
    <pc:docChg chg="undo custSel modSld">
      <pc:chgData name="CAMILA OSPINA AYALA" userId="78f2fe8b-a352-4d21-8a73-8c582c191c8b" providerId="ADAL" clId="{AB7D9840-CA5B-4FFC-A813-372B7C481899}" dt="2021-11-09T13:47:23.937" v="78" actId="14100"/>
      <pc:docMkLst>
        <pc:docMk/>
      </pc:docMkLst>
      <pc:sldChg chg="addSp delSp modSp">
        <pc:chgData name="CAMILA OSPINA AYALA" userId="78f2fe8b-a352-4d21-8a73-8c582c191c8b" providerId="ADAL" clId="{AB7D9840-CA5B-4FFC-A813-372B7C481899}" dt="2021-11-09T13:47:23.937" v="78" actId="14100"/>
        <pc:sldMkLst>
          <pc:docMk/>
          <pc:sldMk cId="3513509246" sldId="256"/>
        </pc:sldMkLst>
        <pc:spChg chg="add mod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14" creationId="{559545BB-4BA5-4679-B338-FBC782E75B16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0" creationId="{F3C4E3DD-1D10-4D5A-81CD-763ECE650A65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1" creationId="{07AE9398-1881-469F-951D-29ADA2B178B6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2" creationId="{F663FA82-1B76-4B5E-939C-AED05F0BEF2C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3" creationId="{44C6A6F1-68BE-4290-B0AA-CE94068E701A}"/>
          </ac:spMkLst>
        </pc:spChg>
        <pc:grpChg chg="del">
          <ac:chgData name="CAMILA OSPINA AYALA" userId="78f2fe8b-a352-4d21-8a73-8c582c191c8b" providerId="ADAL" clId="{AB7D9840-CA5B-4FFC-A813-372B7C481899}" dt="2021-11-09T13:40:49.942" v="9" actId="165"/>
          <ac:grpSpMkLst>
            <pc:docMk/>
            <pc:sldMk cId="3513509246" sldId="256"/>
            <ac:grpSpMk id="4" creationId="{8765459E-59E5-41B9-B49C-6C3B9E76EF99}"/>
          </ac:grpSpMkLst>
        </pc:grpChg>
        <pc:grpChg chg="add mod ord">
          <ac:chgData name="CAMILA OSPINA AYALA" userId="78f2fe8b-a352-4d21-8a73-8c582c191c8b" providerId="ADAL" clId="{AB7D9840-CA5B-4FFC-A813-372B7C481899}" dt="2021-11-09T13:47:14.087" v="75" actId="164"/>
          <ac:grpSpMkLst>
            <pc:docMk/>
            <pc:sldMk cId="3513509246" sldId="256"/>
            <ac:grpSpMk id="15" creationId="{7E83C65F-6016-4224-B46D-4B3AC52081C9}"/>
          </ac:grpSpMkLst>
        </pc:grpChg>
        <pc:grpChg chg="add mod">
          <ac:chgData name="CAMILA OSPINA AYALA" userId="78f2fe8b-a352-4d21-8a73-8c582c191c8b" providerId="ADAL" clId="{AB7D9840-CA5B-4FFC-A813-372B7C481899}" dt="2021-11-09T13:47:14.087" v="75" actId="164"/>
          <ac:grpSpMkLst>
            <pc:docMk/>
            <pc:sldMk cId="3513509246" sldId="256"/>
            <ac:grpSpMk id="16" creationId="{5BD62117-51CC-49FD-9B14-D0BD3D7E5606}"/>
          </ac:grpSpMkLst>
        </pc:grpChg>
        <pc:picChg chg="add mod modCrop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3" creationId="{2748FDED-478B-4CD4-B3DF-3EB6DA924E4F}"/>
          </ac:picMkLst>
        </pc:picChg>
        <pc:picChg chg="del mod">
          <ac:chgData name="CAMILA OSPINA AYALA" userId="78f2fe8b-a352-4d21-8a73-8c582c191c8b" providerId="ADAL" clId="{AB7D9840-CA5B-4FFC-A813-372B7C481899}" dt="2021-11-09T13:41:50.045" v="42" actId="478"/>
          <ac:picMkLst>
            <pc:docMk/>
            <pc:sldMk cId="3513509246" sldId="256"/>
            <ac:picMk id="5" creationId="{6CF85439-18F4-496C-B123-F523870D85F2}"/>
          </ac:picMkLst>
        </pc:picChg>
        <pc:picChg chg="add del mod">
          <ac:chgData name="CAMILA OSPINA AYALA" userId="78f2fe8b-a352-4d21-8a73-8c582c191c8b" providerId="ADAL" clId="{AB7D9840-CA5B-4FFC-A813-372B7C481899}" dt="2021-11-09T13:42:08.734" v="44" actId="478"/>
          <ac:picMkLst>
            <pc:docMk/>
            <pc:sldMk cId="3513509246" sldId="256"/>
            <ac:picMk id="7" creationId="{BD85E238-25E4-4118-9D82-95D7D004AFBD}"/>
          </ac:picMkLst>
        </pc:picChg>
        <pc:picChg chg="add del mod">
          <ac:chgData name="CAMILA OSPINA AYALA" userId="78f2fe8b-a352-4d21-8a73-8c582c191c8b" providerId="ADAL" clId="{AB7D9840-CA5B-4FFC-A813-372B7C481899}" dt="2021-11-09T13:42:31.880" v="47" actId="478"/>
          <ac:picMkLst>
            <pc:docMk/>
            <pc:sldMk cId="3513509246" sldId="256"/>
            <ac:picMk id="9" creationId="{D8BD357C-3D06-4ECE-809D-6CEC56736D79}"/>
          </ac:picMkLst>
        </pc:picChg>
        <pc:picChg chg="add del mod">
          <ac:chgData name="CAMILA OSPINA AYALA" userId="78f2fe8b-a352-4d21-8a73-8c582c191c8b" providerId="ADAL" clId="{AB7D9840-CA5B-4FFC-A813-372B7C481899}" dt="2021-11-09T13:42:57" v="50" actId="478"/>
          <ac:picMkLst>
            <pc:docMk/>
            <pc:sldMk cId="3513509246" sldId="256"/>
            <ac:picMk id="11" creationId="{C95944BA-BEA0-444F-869D-085F7F6C5139}"/>
          </ac:picMkLst>
        </pc:picChg>
        <pc:picChg chg="add mod modCrop">
          <ac:chgData name="CAMILA OSPINA AYALA" userId="78f2fe8b-a352-4d21-8a73-8c582c191c8b" providerId="ADAL" clId="{AB7D9840-CA5B-4FFC-A813-372B7C481899}" dt="2021-11-09T13:47:23.937" v="78" actId="14100"/>
          <ac:picMkLst>
            <pc:docMk/>
            <pc:sldMk cId="3513509246" sldId="256"/>
            <ac:picMk id="13" creationId="{3528E06E-326A-4332-977C-BC054873EE2B}"/>
          </ac:picMkLst>
        </pc:picChg>
        <pc:picChg chg="mod topLvl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18" creationId="{5E2E3BE4-D8DF-45CE-80E8-69E01C751179}"/>
          </ac:picMkLst>
        </pc:picChg>
        <pc:picChg chg="mod topLvl">
          <ac:chgData name="CAMILA OSPINA AYALA" userId="78f2fe8b-a352-4d21-8a73-8c582c191c8b" providerId="ADAL" clId="{AB7D9840-CA5B-4FFC-A813-372B7C481899}" dt="2021-11-09T13:47:14.087" v="75" actId="164"/>
          <ac:picMkLst>
            <pc:docMk/>
            <pc:sldMk cId="3513509246" sldId="256"/>
            <ac:picMk id="20" creationId="{D2B966CF-BD00-4476-8C77-EE159EC54D2D}"/>
          </ac:picMkLst>
        </pc:picChg>
        <pc:picChg chg="mod topLvl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22" creationId="{36557F51-4591-406D-A74B-AA0F86974730}"/>
          </ac:picMkLst>
        </pc:picChg>
        <pc:picChg chg="mod topLvl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24" creationId="{53327AEA-8B5E-4FB8-94DB-CA62964753AB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E441A61-7D5C-4C1E-98C6-A7A05559FB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5C893DF5-944C-4E2F-A0D4-433B9C9AA9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4B69738-C9FF-4A89-8EB5-DBC3DE97B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716A829-1469-4926-951D-D150FD12D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F0E1E362-0F51-4FED-8503-4C04FE575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70281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4798890-C06A-41C7-A3BE-289EE56207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2D998D7E-2AAF-455E-8EB4-3521F9D162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FBB33E8-8A0F-4070-84CC-CBDB4ECAB3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62D9E2C-8F7C-4F95-B296-AFFDC6DFD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4EB4553-B907-42B7-A342-DE03F09AA3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94434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32D1814-E652-4763-959B-5B3D0076D9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FA87DACC-56C5-43D2-A8CB-659FEE9DC4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E1154AC2-BB19-42A6-A5D0-B4B1F5E98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2955D94-8EC9-4B05-8ED6-49284BC640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93F76BC-BD1D-4447-A01A-EB14F7C04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30174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57B74B9-1236-4EF6-A2AD-FBD77A29E4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A55FFCA8-39E7-4850-8B00-4103A9F266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724F01F-4C4D-46EB-BDB2-704D45F6A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761BD0A-4F59-49F2-8D26-159445E53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B46113C-A1F6-4A75-A594-3BE8145DD0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69880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92F70D6-8B5D-4ED4-8971-699B0D180A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DA89B727-33B6-4EBF-8A8C-A068D02DEC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D854AAE-044C-4F7B-B179-122D28F19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FEF864D-E39B-4EBA-ADB0-6FC8F80A2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F7245A7-27CB-404F-9114-9EA9455E8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88444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50C124E-355C-4F2B-A267-D71473808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9ACBD224-AE35-49C8-8091-A0DF82B4BA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02476E06-9702-4449-9D7F-4D5B2C4DAA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E97BEE62-1B25-492C-B3C9-784CB7346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03D264FB-A64C-4422-98CF-5D52F9513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BBD16AB-150D-49AD-A643-4719D0178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51570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6FFFD2D-D51C-4B14-807E-BD69DF11E8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0718BFB2-3770-4AC7-82C4-C1DCD88A10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E93814FB-E5C9-497C-9CB4-8BF6554C99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B96023B8-36E6-4CB5-9E41-F16635B1287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986AFEA6-F7EE-40D3-8374-DC3E161389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F73CD24C-BEEF-42DF-83F5-69BBF5C11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45B80B3A-789E-49A0-B0EB-4E8E1AF04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87457ED8-3AE6-4C6C-88F6-4EFA86832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32892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3098184-B0F1-4D9D-94E5-A5719A4E67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AC6DA878-F54E-449C-A4BB-B82806916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81B821EC-A481-4E3C-A71B-D045345CD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0F8B1289-AE6D-4409-B6BD-158A57831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92275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23C05A06-C5BF-422A-B960-D0F65EE40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D5CD1DDB-EA0F-469A-B906-80B9969CE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851136C3-2EB9-4C4B-88C4-8903884DCF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74861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9051EE3-341C-4883-8F06-C319E12C3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1AA2537E-3EC1-46E4-8FF1-55E94EA5A6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D122A7DD-400B-4314-8235-2AEACD68E6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3B8DD15D-B411-438F-8E50-106643F96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4304E1C5-DAC9-4E86-9847-4DD370402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91B275FA-A957-4003-99F7-D2E08B1BC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49979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0D118D9-8C35-4ED7-BD2F-77DE5FD748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9683050A-ABAB-475B-98D3-F8B43F1A7A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B9D132FE-13F8-42D5-BCD8-9075CBD790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2EB35309-1F4F-4D7F-B416-65F9F7377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88C6CB88-8BC5-4F7E-81CF-3DE646631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2323CD44-AC7A-4A16-9622-EB8385E81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54674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01E297AD-1012-46EC-B217-7008C3B0F0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CAE9DCFF-2DF6-4C37-AE01-935A5D362B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665C307-17D7-40CA-B656-ADC9854D13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B62F454B-1DAC-4C5F-A0CE-CD5D2B1DBD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141D767-ADE0-4ED5-ABEB-74D5AD587C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71938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mp"/><Relationship Id="rId3" Type="http://schemas.openxmlformats.org/officeDocument/2006/relationships/image" Target="../media/image2.tmp"/><Relationship Id="rId7" Type="http://schemas.openxmlformats.org/officeDocument/2006/relationships/image" Target="../media/image6.tmp"/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mp"/><Relationship Id="rId5" Type="http://schemas.openxmlformats.org/officeDocument/2006/relationships/image" Target="../media/image4.tmp"/><Relationship Id="rId10" Type="http://schemas.openxmlformats.org/officeDocument/2006/relationships/image" Target="../media/image9.tmp"/><Relationship Id="rId4" Type="http://schemas.openxmlformats.org/officeDocument/2006/relationships/image" Target="../media/image3.tmp"/><Relationship Id="rId9" Type="http://schemas.openxmlformats.org/officeDocument/2006/relationships/image" Target="../media/image8.tm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Agrupar 67">
            <a:extLst>
              <a:ext uri="{FF2B5EF4-FFF2-40B4-BE49-F238E27FC236}">
                <a16:creationId xmlns:a16="http://schemas.microsoft.com/office/drawing/2014/main" id="{B718D4B1-6120-43FA-A5BD-65AD5B22AD97}"/>
              </a:ext>
            </a:extLst>
          </p:cNvPr>
          <p:cNvGrpSpPr/>
          <p:nvPr/>
        </p:nvGrpSpPr>
        <p:grpSpPr>
          <a:xfrm>
            <a:off x="6002592" y="659593"/>
            <a:ext cx="4921077" cy="5584552"/>
            <a:chOff x="6001726" y="619191"/>
            <a:chExt cx="4921077" cy="5584552"/>
          </a:xfrm>
        </p:grpSpPr>
        <p:pic>
          <p:nvPicPr>
            <p:cNvPr id="66" name="Imagem 65">
              <a:extLst>
                <a:ext uri="{FF2B5EF4-FFF2-40B4-BE49-F238E27FC236}">
                  <a16:creationId xmlns:a16="http://schemas.microsoft.com/office/drawing/2014/main" id="{3C0B9047-739F-490E-8616-A342857A3B2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28636" y="5385754"/>
              <a:ext cx="4894167" cy="817989"/>
            </a:xfrm>
            <a:prstGeom prst="rect">
              <a:avLst/>
            </a:prstGeom>
          </p:spPr>
        </p:pic>
        <p:pic>
          <p:nvPicPr>
            <p:cNvPr id="39" name="Imagem 38" descr="Gráfico, Gráfico de barras&#10;&#10;Descrição gerada automaticamente">
              <a:extLst>
                <a:ext uri="{FF2B5EF4-FFF2-40B4-BE49-F238E27FC236}">
                  <a16:creationId xmlns:a16="http://schemas.microsoft.com/office/drawing/2014/main" id="{401EE87B-5F5C-4640-9CCB-754B9688B5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9312" b="15226"/>
            <a:stretch/>
          </p:blipFill>
          <p:spPr>
            <a:xfrm>
              <a:off x="6001726" y="1762120"/>
              <a:ext cx="4898610" cy="3598351"/>
            </a:xfrm>
            <a:prstGeom prst="rect">
              <a:avLst/>
            </a:prstGeom>
          </p:spPr>
        </p:pic>
        <p:grpSp>
          <p:nvGrpSpPr>
            <p:cNvPr id="13" name="Agrupar 12">
              <a:extLst>
                <a:ext uri="{FF2B5EF4-FFF2-40B4-BE49-F238E27FC236}">
                  <a16:creationId xmlns:a16="http://schemas.microsoft.com/office/drawing/2014/main" id="{EF3BA452-1BB3-40B4-B39D-191449E392F2}"/>
                </a:ext>
              </a:extLst>
            </p:cNvPr>
            <p:cNvGrpSpPr/>
            <p:nvPr/>
          </p:nvGrpSpPr>
          <p:grpSpPr>
            <a:xfrm>
              <a:off x="6096000" y="619191"/>
              <a:ext cx="4780567" cy="981212"/>
              <a:chOff x="6096000" y="619191"/>
              <a:chExt cx="4780567" cy="981212"/>
            </a:xfrm>
          </p:grpSpPr>
          <p:pic>
            <p:nvPicPr>
              <p:cNvPr id="9" name="Imagem 8" descr="Uma imagem contendo Retângulo&#10;&#10;Descrição gerada automaticamente">
                <a:extLst>
                  <a:ext uri="{FF2B5EF4-FFF2-40B4-BE49-F238E27FC236}">
                    <a16:creationId xmlns:a16="http://schemas.microsoft.com/office/drawing/2014/main" id="{ACF0F0EA-961F-40DC-A761-A387CC54E8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96000" y="619191"/>
                <a:ext cx="4780567" cy="981212"/>
              </a:xfrm>
              <a:prstGeom prst="rect">
                <a:avLst/>
              </a:prstGeom>
            </p:spPr>
          </p:pic>
          <p:sp>
            <p:nvSpPr>
              <p:cNvPr id="64" name="Retângulo 63">
                <a:extLst>
                  <a:ext uri="{FF2B5EF4-FFF2-40B4-BE49-F238E27FC236}">
                    <a16:creationId xmlns:a16="http://schemas.microsoft.com/office/drawing/2014/main" id="{401326BD-EB88-417D-8D4D-D2FA2936BED1}"/>
                  </a:ext>
                </a:extLst>
              </p:cNvPr>
              <p:cNvSpPr/>
              <p:nvPr/>
            </p:nvSpPr>
            <p:spPr>
              <a:xfrm>
                <a:off x="7916926" y="709575"/>
                <a:ext cx="2475979" cy="342000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 w="19050">
                <a:solidFill>
                  <a:schemeClr val="bg2">
                    <a:lumMod val="1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65" name="Retângulo 64">
                <a:extLst>
                  <a:ext uri="{FF2B5EF4-FFF2-40B4-BE49-F238E27FC236}">
                    <a16:creationId xmlns:a16="http://schemas.microsoft.com/office/drawing/2014/main" id="{95764C5A-11C2-4D84-97AD-0DA4244FC029}"/>
                  </a:ext>
                </a:extLst>
              </p:cNvPr>
              <p:cNvSpPr/>
              <p:nvPr/>
            </p:nvSpPr>
            <p:spPr>
              <a:xfrm>
                <a:off x="6502370" y="1193135"/>
                <a:ext cx="2475979" cy="342000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 w="19050">
                <a:solidFill>
                  <a:schemeClr val="bg2">
                    <a:lumMod val="1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</p:grpSp>
        <p:sp>
          <p:nvSpPr>
            <p:cNvPr id="67" name="Retângulo 66">
              <a:extLst>
                <a:ext uri="{FF2B5EF4-FFF2-40B4-BE49-F238E27FC236}">
                  <a16:creationId xmlns:a16="http://schemas.microsoft.com/office/drawing/2014/main" id="{67CD50A1-6B7A-447E-9A01-26CB9390E2BE}"/>
                </a:ext>
              </a:extLst>
            </p:cNvPr>
            <p:cNvSpPr/>
            <p:nvPr/>
          </p:nvSpPr>
          <p:spPr>
            <a:xfrm>
              <a:off x="7564971" y="5411482"/>
              <a:ext cx="690267" cy="397087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 w="19050">
              <a:solidFill>
                <a:schemeClr val="bg2">
                  <a:lumMod val="1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dirty="0"/>
            </a:p>
          </p:txBody>
        </p:sp>
      </p:grpSp>
      <p:grpSp>
        <p:nvGrpSpPr>
          <p:cNvPr id="70" name="Agrupar 69">
            <a:extLst>
              <a:ext uri="{FF2B5EF4-FFF2-40B4-BE49-F238E27FC236}">
                <a16:creationId xmlns:a16="http://schemas.microsoft.com/office/drawing/2014/main" id="{8BF139BC-B4C3-42D0-80D4-3A1D2A0BB406}"/>
              </a:ext>
            </a:extLst>
          </p:cNvPr>
          <p:cNvGrpSpPr/>
          <p:nvPr/>
        </p:nvGrpSpPr>
        <p:grpSpPr>
          <a:xfrm>
            <a:off x="1269197" y="751185"/>
            <a:ext cx="4602619" cy="5465236"/>
            <a:chOff x="1269197" y="751185"/>
            <a:chExt cx="4602619" cy="5465236"/>
          </a:xfrm>
        </p:grpSpPr>
        <p:grpSp>
          <p:nvGrpSpPr>
            <p:cNvPr id="7" name="Agrupar 6">
              <a:extLst>
                <a:ext uri="{FF2B5EF4-FFF2-40B4-BE49-F238E27FC236}">
                  <a16:creationId xmlns:a16="http://schemas.microsoft.com/office/drawing/2014/main" id="{9076C046-96DD-4900-8425-A1C84D54CDA0}"/>
                </a:ext>
              </a:extLst>
            </p:cNvPr>
            <p:cNvGrpSpPr/>
            <p:nvPr/>
          </p:nvGrpSpPr>
          <p:grpSpPr>
            <a:xfrm>
              <a:off x="1269197" y="751185"/>
              <a:ext cx="4602619" cy="5465236"/>
              <a:chOff x="1269197" y="751185"/>
              <a:chExt cx="4602619" cy="5465236"/>
            </a:xfrm>
          </p:grpSpPr>
          <p:pic>
            <p:nvPicPr>
              <p:cNvPr id="38" name="Imagem 37" descr="Gráfico, Gráfico de barras&#10;&#10;Descrição gerada automaticamente">
                <a:extLst>
                  <a:ext uri="{FF2B5EF4-FFF2-40B4-BE49-F238E27FC236}">
                    <a16:creationId xmlns:a16="http://schemas.microsoft.com/office/drawing/2014/main" id="{9259ACB8-1BC1-4E3D-AA8A-1DC4C5C97CF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0150"/>
              <a:stretch/>
            </p:blipFill>
            <p:spPr>
              <a:xfrm>
                <a:off x="1269197" y="1269677"/>
                <a:ext cx="4602619" cy="4946744"/>
              </a:xfrm>
              <a:prstGeom prst="rect">
                <a:avLst/>
              </a:prstGeom>
            </p:spPr>
          </p:pic>
          <p:sp>
            <p:nvSpPr>
              <p:cNvPr id="36" name="Retângulo 35">
                <a:extLst>
                  <a:ext uri="{FF2B5EF4-FFF2-40B4-BE49-F238E27FC236}">
                    <a16:creationId xmlns:a16="http://schemas.microsoft.com/office/drawing/2014/main" id="{D230DE21-C5E1-480F-9D31-B83499BD0BDA}"/>
                  </a:ext>
                </a:extLst>
              </p:cNvPr>
              <p:cNvSpPr/>
              <p:nvPr/>
            </p:nvSpPr>
            <p:spPr>
              <a:xfrm>
                <a:off x="1510748" y="751185"/>
                <a:ext cx="4209396" cy="360000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 w="19050">
                <a:solidFill>
                  <a:schemeClr val="bg2">
                    <a:lumMod val="1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45" name="Retângulo 44">
                <a:extLst>
                  <a:ext uri="{FF2B5EF4-FFF2-40B4-BE49-F238E27FC236}">
                    <a16:creationId xmlns:a16="http://schemas.microsoft.com/office/drawing/2014/main" id="{0D078D83-0224-46FA-91FE-0A916212D302}"/>
                  </a:ext>
                </a:extLst>
              </p:cNvPr>
              <p:cNvSpPr/>
              <p:nvPr/>
            </p:nvSpPr>
            <p:spPr>
              <a:xfrm>
                <a:off x="1510748" y="5408323"/>
                <a:ext cx="750919" cy="360000"/>
              </a:xfrm>
              <a:prstGeom prst="rect">
                <a:avLst/>
              </a:prstGeom>
              <a:solidFill>
                <a:srgbClr val="0BDD0B"/>
              </a:solidFill>
              <a:ln w="19050">
                <a:solidFill>
                  <a:schemeClr val="bg2">
                    <a:lumMod val="1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47" name="Retângulo 46">
                <a:extLst>
                  <a:ext uri="{FF2B5EF4-FFF2-40B4-BE49-F238E27FC236}">
                    <a16:creationId xmlns:a16="http://schemas.microsoft.com/office/drawing/2014/main" id="{D92C0AD5-AD7C-49A1-B42A-B05405678E4C}"/>
                  </a:ext>
                </a:extLst>
              </p:cNvPr>
              <p:cNvSpPr/>
              <p:nvPr/>
            </p:nvSpPr>
            <p:spPr>
              <a:xfrm>
                <a:off x="2261667" y="5417718"/>
                <a:ext cx="892350" cy="359999"/>
              </a:xfrm>
              <a:prstGeom prst="rect">
                <a:avLst/>
              </a:prstGeom>
              <a:solidFill>
                <a:srgbClr val="FFFF00"/>
              </a:solidFill>
              <a:ln w="19050">
                <a:solidFill>
                  <a:schemeClr val="bg2">
                    <a:lumMod val="1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</p:grpSp>
        <p:sp>
          <p:nvSpPr>
            <p:cNvPr id="48" name="Retângulo 47">
              <a:extLst>
                <a:ext uri="{FF2B5EF4-FFF2-40B4-BE49-F238E27FC236}">
                  <a16:creationId xmlns:a16="http://schemas.microsoft.com/office/drawing/2014/main" id="{08B0B275-7C47-4899-94A2-863FA4B60537}"/>
                </a:ext>
              </a:extLst>
            </p:cNvPr>
            <p:cNvSpPr/>
            <p:nvPr/>
          </p:nvSpPr>
          <p:spPr>
            <a:xfrm>
              <a:off x="3163366" y="5407660"/>
              <a:ext cx="533991" cy="372258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 w="19050">
              <a:solidFill>
                <a:schemeClr val="bg2">
                  <a:lumMod val="1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</p:grpSp>
      <p:grpSp>
        <p:nvGrpSpPr>
          <p:cNvPr id="69" name="Agrupar 68">
            <a:extLst>
              <a:ext uri="{FF2B5EF4-FFF2-40B4-BE49-F238E27FC236}">
                <a16:creationId xmlns:a16="http://schemas.microsoft.com/office/drawing/2014/main" id="{4E38DB9F-8752-45BA-8ECD-56850A61132E}"/>
              </a:ext>
            </a:extLst>
          </p:cNvPr>
          <p:cNvGrpSpPr/>
          <p:nvPr/>
        </p:nvGrpSpPr>
        <p:grpSpPr>
          <a:xfrm>
            <a:off x="20935" y="723199"/>
            <a:ext cx="1292449" cy="4929660"/>
            <a:chOff x="20935" y="723199"/>
            <a:chExt cx="1292449" cy="4929660"/>
          </a:xfrm>
        </p:grpSpPr>
        <p:sp>
          <p:nvSpPr>
            <p:cNvPr id="19" name="CaixaDeTexto 18">
              <a:extLst>
                <a:ext uri="{FF2B5EF4-FFF2-40B4-BE49-F238E27FC236}">
                  <a16:creationId xmlns:a16="http://schemas.microsoft.com/office/drawing/2014/main" id="{AC4C3DC5-C950-4469-B152-4E43DE1B5036}"/>
                </a:ext>
              </a:extLst>
            </p:cNvPr>
            <p:cNvSpPr txBox="1"/>
            <p:nvPr/>
          </p:nvSpPr>
          <p:spPr>
            <a:xfrm>
              <a:off x="83743" y="723199"/>
              <a:ext cx="1166832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lation process</a:t>
              </a:r>
              <a:endParaRPr lang="pt-BR" sz="13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CaixaDeTexto 20">
              <a:extLst>
                <a:ext uri="{FF2B5EF4-FFF2-40B4-BE49-F238E27FC236}">
                  <a16:creationId xmlns:a16="http://schemas.microsoft.com/office/drawing/2014/main" id="{1CA3E8AA-CACE-4939-89EE-2E2C569FA7D2}"/>
                </a:ext>
              </a:extLst>
            </p:cNvPr>
            <p:cNvSpPr txBox="1"/>
            <p:nvPr/>
          </p:nvSpPr>
          <p:spPr>
            <a:xfrm>
              <a:off x="83743" y="1269677"/>
              <a:ext cx="1166832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ntent validity </a:t>
              </a:r>
              <a:endParaRPr lang="pt-BR" sz="13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CaixaDeTexto 22">
              <a:extLst>
                <a:ext uri="{FF2B5EF4-FFF2-40B4-BE49-F238E27FC236}">
                  <a16:creationId xmlns:a16="http://schemas.microsoft.com/office/drawing/2014/main" id="{2223FC15-4D9E-4B6E-8A58-F6F5B19D2659}"/>
                </a:ext>
              </a:extLst>
            </p:cNvPr>
            <p:cNvSpPr txBox="1"/>
            <p:nvPr/>
          </p:nvSpPr>
          <p:spPr>
            <a:xfrm>
              <a:off x="83743" y="1782298"/>
              <a:ext cx="1166832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ypotheses testing </a:t>
              </a:r>
              <a:endParaRPr lang="pt-BR" sz="13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CaixaDeTexto 24">
              <a:extLst>
                <a:ext uri="{FF2B5EF4-FFF2-40B4-BE49-F238E27FC236}">
                  <a16:creationId xmlns:a16="http://schemas.microsoft.com/office/drawing/2014/main" id="{599088B4-5A7A-4909-B659-A569413595EE}"/>
                </a:ext>
              </a:extLst>
            </p:cNvPr>
            <p:cNvSpPr txBox="1"/>
            <p:nvPr/>
          </p:nvSpPr>
          <p:spPr>
            <a:xfrm>
              <a:off x="83743" y="2235135"/>
              <a:ext cx="1166832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ructural validity </a:t>
              </a:r>
              <a:endParaRPr lang="pt-BR" sz="13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CaixaDeTexto 25">
              <a:extLst>
                <a:ext uri="{FF2B5EF4-FFF2-40B4-BE49-F238E27FC236}">
                  <a16:creationId xmlns:a16="http://schemas.microsoft.com/office/drawing/2014/main" id="{000E1D5E-750D-4A86-887D-B8AE804C8B3B}"/>
                </a:ext>
              </a:extLst>
            </p:cNvPr>
            <p:cNvSpPr txBox="1"/>
            <p:nvPr/>
          </p:nvSpPr>
          <p:spPr>
            <a:xfrm>
              <a:off x="41870" y="2803718"/>
              <a:ext cx="1166832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riterion validity </a:t>
              </a:r>
              <a:endParaRPr lang="pt-BR" sz="13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CaixaDeTexto 26">
              <a:extLst>
                <a:ext uri="{FF2B5EF4-FFF2-40B4-BE49-F238E27FC236}">
                  <a16:creationId xmlns:a16="http://schemas.microsoft.com/office/drawing/2014/main" id="{EDE3F7CC-9264-4DB8-90A9-8EF5F9D9F236}"/>
                </a:ext>
              </a:extLst>
            </p:cNvPr>
            <p:cNvSpPr txBox="1"/>
            <p:nvPr/>
          </p:nvSpPr>
          <p:spPr>
            <a:xfrm>
              <a:off x="83743" y="3345509"/>
              <a:ext cx="1166832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nal consistency </a:t>
              </a:r>
              <a:endParaRPr lang="pt-BR" sz="13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CaixaDeTexto 27">
              <a:extLst>
                <a:ext uri="{FF2B5EF4-FFF2-40B4-BE49-F238E27FC236}">
                  <a16:creationId xmlns:a16="http://schemas.microsoft.com/office/drawing/2014/main" id="{4932058E-A20F-4F48-953C-EDBFFCE96125}"/>
                </a:ext>
              </a:extLst>
            </p:cNvPr>
            <p:cNvSpPr txBox="1"/>
            <p:nvPr/>
          </p:nvSpPr>
          <p:spPr>
            <a:xfrm>
              <a:off x="83743" y="3816584"/>
              <a:ext cx="1166832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liability Test-retest</a:t>
              </a:r>
              <a:endParaRPr lang="pt-BR" sz="13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CaixaDeTexto 28">
              <a:extLst>
                <a:ext uri="{FF2B5EF4-FFF2-40B4-BE49-F238E27FC236}">
                  <a16:creationId xmlns:a16="http://schemas.microsoft.com/office/drawing/2014/main" id="{5751DFF6-0BE3-49DA-9152-418AC0EC2206}"/>
                </a:ext>
              </a:extLst>
            </p:cNvPr>
            <p:cNvSpPr txBox="1"/>
            <p:nvPr/>
          </p:nvSpPr>
          <p:spPr>
            <a:xfrm>
              <a:off x="41870" y="4328477"/>
              <a:ext cx="1250578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asurement invariance </a:t>
              </a:r>
              <a:endParaRPr lang="pt-BR" sz="13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CaixaDeTexto 33">
              <a:extLst>
                <a:ext uri="{FF2B5EF4-FFF2-40B4-BE49-F238E27FC236}">
                  <a16:creationId xmlns:a16="http://schemas.microsoft.com/office/drawing/2014/main" id="{0CE25098-89F7-4813-B544-78663C75256E}"/>
                </a:ext>
              </a:extLst>
            </p:cNvPr>
            <p:cNvSpPr txBox="1"/>
            <p:nvPr/>
          </p:nvSpPr>
          <p:spPr>
            <a:xfrm>
              <a:off x="20935" y="4848578"/>
              <a:ext cx="1292449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sponsiveness</a:t>
              </a:r>
              <a:endParaRPr lang="pt-BR" sz="13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CaixaDeTexto 34">
              <a:extLst>
                <a:ext uri="{FF2B5EF4-FFF2-40B4-BE49-F238E27FC236}">
                  <a16:creationId xmlns:a16="http://schemas.microsoft.com/office/drawing/2014/main" id="{2843D0DD-7137-4E59-8F50-E9A10B68152C}"/>
                </a:ext>
              </a:extLst>
            </p:cNvPr>
            <p:cNvSpPr txBox="1"/>
            <p:nvPr/>
          </p:nvSpPr>
          <p:spPr>
            <a:xfrm>
              <a:off x="83743" y="5360471"/>
              <a:ext cx="1166832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</a:t>
              </a:r>
              <a:endParaRPr lang="pt-BR" sz="13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7" name="Retângulo 36">
            <a:extLst>
              <a:ext uri="{FF2B5EF4-FFF2-40B4-BE49-F238E27FC236}">
                <a16:creationId xmlns:a16="http://schemas.microsoft.com/office/drawing/2014/main" id="{F8998751-4BDE-49F4-8B5B-A4EEE308E80B}"/>
              </a:ext>
            </a:extLst>
          </p:cNvPr>
          <p:cNvSpPr/>
          <p:nvPr/>
        </p:nvSpPr>
        <p:spPr>
          <a:xfrm>
            <a:off x="147048" y="224971"/>
            <a:ext cx="11885925" cy="339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5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dditional </a:t>
            </a:r>
            <a:r>
              <a:rPr lang="en-US" sz="1500" b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le </a:t>
            </a:r>
            <a:r>
              <a:rPr lang="en-US" sz="1500" b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7. </a:t>
            </a:r>
            <a:r>
              <a:rPr lang="en-US" sz="15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OSMIN classification of the methodological quality of the EAT of the original study versus the studies included in this review</a:t>
            </a:r>
            <a:endParaRPr lang="pt-BR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CaixaDeTexto 39">
            <a:extLst>
              <a:ext uri="{FF2B5EF4-FFF2-40B4-BE49-F238E27FC236}">
                <a16:creationId xmlns:a16="http://schemas.microsoft.com/office/drawing/2014/main" id="{F9AF426F-ACBD-4944-B0EA-BB8BB10D6D2D}"/>
              </a:ext>
            </a:extLst>
          </p:cNvPr>
          <p:cNvSpPr txBox="1"/>
          <p:nvPr/>
        </p:nvSpPr>
        <p:spPr>
          <a:xfrm>
            <a:off x="2247724" y="6104451"/>
            <a:ext cx="264556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T </a:t>
            </a:r>
            <a:r>
              <a:rPr lang="pt-BR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</a:t>
            </a:r>
            <a:r>
              <a:rPr lang="pt-B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pt-B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41" name="CaixaDeTexto 40">
            <a:extLst>
              <a:ext uri="{FF2B5EF4-FFF2-40B4-BE49-F238E27FC236}">
                <a16:creationId xmlns:a16="http://schemas.microsoft.com/office/drawing/2014/main" id="{8DE9B822-B5DE-4688-8146-5D508A74E52C}"/>
              </a:ext>
            </a:extLst>
          </p:cNvPr>
          <p:cNvSpPr txBox="1"/>
          <p:nvPr/>
        </p:nvSpPr>
        <p:spPr>
          <a:xfrm>
            <a:off x="7402806" y="6104451"/>
            <a:ext cx="26455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T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luded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ies</a:t>
            </a:r>
            <a:endParaRPr lang="pt-B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CaixaDeTexto 41">
            <a:extLst>
              <a:ext uri="{FF2B5EF4-FFF2-40B4-BE49-F238E27FC236}">
                <a16:creationId xmlns:a16="http://schemas.microsoft.com/office/drawing/2014/main" id="{C0C8B480-951E-404C-ADEE-AAEB646375C9}"/>
              </a:ext>
            </a:extLst>
          </p:cNvPr>
          <p:cNvSpPr txBox="1"/>
          <p:nvPr/>
        </p:nvSpPr>
        <p:spPr>
          <a:xfrm>
            <a:off x="258105" y="6216421"/>
            <a:ext cx="11774868" cy="4924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n-CA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Note: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hypotheses </a:t>
            </a:r>
            <a:r>
              <a:rPr lang="en-US" sz="1300">
                <a:latin typeface="Times New Roman" panose="02020603050405020304" pitchFamily="18" charset="0"/>
                <a:ea typeface="Calibri" panose="020F0502020204030204" pitchFamily="34" charset="0"/>
              </a:rPr>
              <a:t>testing </a:t>
            </a:r>
            <a:r>
              <a:rPr lang="en-US" sz="1300">
                <a:latin typeface="Times New Roman" panose="02020603050405020304" pitchFamily="18" charset="0"/>
                <a:ea typeface="Calibri" panose="020F0502020204030204" pitchFamily="34" charset="0"/>
              </a:rPr>
              <a:t>considers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(criterion validity); structural validity considers (construct validity) and criterion validity </a:t>
            </a:r>
            <a:r>
              <a:rPr lang="en-US" sz="13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considers (diagnostic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performance)</a:t>
            </a:r>
            <a:endParaRPr lang="pt-BR" sz="130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grpSp>
        <p:nvGrpSpPr>
          <p:cNvPr id="49" name="Agrupar 48">
            <a:extLst>
              <a:ext uri="{FF2B5EF4-FFF2-40B4-BE49-F238E27FC236}">
                <a16:creationId xmlns:a16="http://schemas.microsoft.com/office/drawing/2014/main" id="{21D9533D-844D-49D2-B61F-D9A33798CECB}"/>
              </a:ext>
            </a:extLst>
          </p:cNvPr>
          <p:cNvGrpSpPr/>
          <p:nvPr/>
        </p:nvGrpSpPr>
        <p:grpSpPr>
          <a:xfrm>
            <a:off x="10900336" y="2604952"/>
            <a:ext cx="2169672" cy="2359042"/>
            <a:chOff x="9774014" y="2473794"/>
            <a:chExt cx="2302081" cy="2359042"/>
          </a:xfrm>
        </p:grpSpPr>
        <p:grpSp>
          <p:nvGrpSpPr>
            <p:cNvPr id="50" name="Agrupar 49">
              <a:extLst>
                <a:ext uri="{FF2B5EF4-FFF2-40B4-BE49-F238E27FC236}">
                  <a16:creationId xmlns:a16="http://schemas.microsoft.com/office/drawing/2014/main" id="{DA3C5A63-5608-497A-A5A8-6BB90B7A9947}"/>
                </a:ext>
              </a:extLst>
            </p:cNvPr>
            <p:cNvGrpSpPr/>
            <p:nvPr/>
          </p:nvGrpSpPr>
          <p:grpSpPr>
            <a:xfrm>
              <a:off x="9774014" y="2473794"/>
              <a:ext cx="2302081" cy="1943113"/>
              <a:chOff x="9774014" y="2473794"/>
              <a:chExt cx="2302081" cy="1943113"/>
            </a:xfrm>
          </p:grpSpPr>
          <p:pic>
            <p:nvPicPr>
              <p:cNvPr id="53" name="Imagem 52">
                <a:extLst>
                  <a:ext uri="{FF2B5EF4-FFF2-40B4-BE49-F238E27FC236}">
                    <a16:creationId xmlns:a16="http://schemas.microsoft.com/office/drawing/2014/main" id="{D64CEBC3-CB68-40E3-B2C1-A7FCFA7E171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775380" y="3452723"/>
                <a:ext cx="257211" cy="228632"/>
              </a:xfrm>
              <a:prstGeom prst="rect">
                <a:avLst/>
              </a:prstGeom>
            </p:spPr>
          </p:pic>
          <p:grpSp>
            <p:nvGrpSpPr>
              <p:cNvPr id="54" name="Agrupar 53">
                <a:extLst>
                  <a:ext uri="{FF2B5EF4-FFF2-40B4-BE49-F238E27FC236}">
                    <a16:creationId xmlns:a16="http://schemas.microsoft.com/office/drawing/2014/main" id="{FE652C29-CB5C-434E-BC93-41A15848B128}"/>
                  </a:ext>
                </a:extLst>
              </p:cNvPr>
              <p:cNvGrpSpPr/>
              <p:nvPr/>
            </p:nvGrpSpPr>
            <p:grpSpPr>
              <a:xfrm>
                <a:off x="9774014" y="2473794"/>
                <a:ext cx="2302081" cy="1943113"/>
                <a:chOff x="9774014" y="2449321"/>
                <a:chExt cx="2302081" cy="1943113"/>
              </a:xfrm>
            </p:grpSpPr>
            <p:pic>
              <p:nvPicPr>
                <p:cNvPr id="55" name="Imagem 54">
                  <a:extLst>
                    <a:ext uri="{FF2B5EF4-FFF2-40B4-BE49-F238E27FC236}">
                      <a16:creationId xmlns:a16="http://schemas.microsoft.com/office/drawing/2014/main" id="{42CD3CF8-DC2E-4C8D-B735-39EA91ABC61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789893" y="2970554"/>
                  <a:ext cx="228632" cy="257211"/>
                </a:xfrm>
                <a:prstGeom prst="rect">
                  <a:avLst/>
                </a:prstGeom>
              </p:spPr>
            </p:pic>
            <p:pic>
              <p:nvPicPr>
                <p:cNvPr id="56" name="Imagem 55">
                  <a:extLst>
                    <a:ext uri="{FF2B5EF4-FFF2-40B4-BE49-F238E27FC236}">
                      <a16:creationId xmlns:a16="http://schemas.microsoft.com/office/drawing/2014/main" id="{5271A8C7-1E34-4510-B9A9-CA7B116865B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774014" y="2469841"/>
                  <a:ext cx="257211" cy="266737"/>
                </a:xfrm>
                <a:prstGeom prst="rect">
                  <a:avLst/>
                </a:prstGeom>
              </p:spPr>
            </p:pic>
            <p:pic>
              <p:nvPicPr>
                <p:cNvPr id="57" name="Imagem 56">
                  <a:extLst>
                    <a:ext uri="{FF2B5EF4-FFF2-40B4-BE49-F238E27FC236}">
                      <a16:creationId xmlns:a16="http://schemas.microsoft.com/office/drawing/2014/main" id="{47BBC2D1-35EB-4A60-A490-AE9ACB0D3C5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799419" y="4163802"/>
                  <a:ext cx="238158" cy="228632"/>
                </a:xfrm>
                <a:prstGeom prst="rect">
                  <a:avLst/>
                </a:prstGeom>
              </p:spPr>
            </p:pic>
            <p:sp>
              <p:nvSpPr>
                <p:cNvPr id="58" name="CaixaDeTexto 57">
                  <a:extLst>
                    <a:ext uri="{FF2B5EF4-FFF2-40B4-BE49-F238E27FC236}">
                      <a16:creationId xmlns:a16="http://schemas.microsoft.com/office/drawing/2014/main" id="{FFC6DD75-40B0-4ACE-A17E-21A7BECD6CFE}"/>
                    </a:ext>
                  </a:extLst>
                </p:cNvPr>
                <p:cNvSpPr txBox="1"/>
                <p:nvPr/>
              </p:nvSpPr>
              <p:spPr>
                <a:xfrm>
                  <a:off x="10005825" y="2449321"/>
                  <a:ext cx="188716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ry good</a:t>
                  </a:r>
                  <a:endParaRPr lang="pt-BR" sz="12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" name="CaixaDeTexto 58">
                  <a:extLst>
                    <a:ext uri="{FF2B5EF4-FFF2-40B4-BE49-F238E27FC236}">
                      <a16:creationId xmlns:a16="http://schemas.microsoft.com/office/drawing/2014/main" id="{11668080-0518-498F-A430-481348DD2716}"/>
                    </a:ext>
                  </a:extLst>
                </p:cNvPr>
                <p:cNvSpPr txBox="1"/>
                <p:nvPr/>
              </p:nvSpPr>
              <p:spPr>
                <a:xfrm>
                  <a:off x="10005824" y="2945271"/>
                  <a:ext cx="188716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dequate</a:t>
                  </a:r>
                  <a:endParaRPr lang="pt-BR" sz="12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" name="CaixaDeTexto 59">
                  <a:extLst>
                    <a:ext uri="{FF2B5EF4-FFF2-40B4-BE49-F238E27FC236}">
                      <a16:creationId xmlns:a16="http://schemas.microsoft.com/office/drawing/2014/main" id="{73BFA8CB-37F7-4F3B-A9B0-BF70299C82F4}"/>
                    </a:ext>
                  </a:extLst>
                </p:cNvPr>
                <p:cNvSpPr txBox="1"/>
                <p:nvPr/>
              </p:nvSpPr>
              <p:spPr>
                <a:xfrm>
                  <a:off x="10018525" y="3413151"/>
                  <a:ext cx="188716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oubtful</a:t>
                  </a:r>
                  <a:endParaRPr lang="pt-BR" sz="12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" name="CaixaDeTexto 60">
                  <a:extLst>
                    <a:ext uri="{FF2B5EF4-FFF2-40B4-BE49-F238E27FC236}">
                      <a16:creationId xmlns:a16="http://schemas.microsoft.com/office/drawing/2014/main" id="{A297613B-B327-46D7-94C4-B364628C4C81}"/>
                    </a:ext>
                  </a:extLst>
                </p:cNvPr>
                <p:cNvSpPr txBox="1"/>
                <p:nvPr/>
              </p:nvSpPr>
              <p:spPr>
                <a:xfrm>
                  <a:off x="10031225" y="4102757"/>
                  <a:ext cx="204487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ot reported</a:t>
                  </a:r>
                  <a:endParaRPr lang="pt-BR" sz="12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62" name="Imagem 61">
                  <a:extLst>
                    <a:ext uri="{FF2B5EF4-FFF2-40B4-BE49-F238E27FC236}">
                      <a16:creationId xmlns:a16="http://schemas.microsoft.com/office/drawing/2014/main" id="{B156768B-6BA2-4123-AB3C-C16CCD6D01B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6506" t="18695" r="38910" b="40626"/>
                <a:stretch/>
              </p:blipFill>
              <p:spPr>
                <a:xfrm>
                  <a:off x="9780366" y="3807602"/>
                  <a:ext cx="257211" cy="228632"/>
                </a:xfrm>
                <a:prstGeom prst="rect">
                  <a:avLst/>
                </a:prstGeom>
              </p:spPr>
            </p:pic>
            <p:sp>
              <p:nvSpPr>
                <p:cNvPr id="63" name="CaixaDeTexto 62">
                  <a:extLst>
                    <a:ext uri="{FF2B5EF4-FFF2-40B4-BE49-F238E27FC236}">
                      <a16:creationId xmlns:a16="http://schemas.microsoft.com/office/drawing/2014/main" id="{41FC9007-EE5C-4979-92D1-FD6D1CC476AF}"/>
                    </a:ext>
                  </a:extLst>
                </p:cNvPr>
                <p:cNvSpPr txBox="1"/>
                <p:nvPr/>
              </p:nvSpPr>
              <p:spPr>
                <a:xfrm>
                  <a:off x="10031225" y="3761718"/>
                  <a:ext cx="188716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nadequate</a:t>
                  </a:r>
                  <a:endParaRPr lang="pt-BR" sz="12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51" name="Retângulo 50">
              <a:extLst>
                <a:ext uri="{FF2B5EF4-FFF2-40B4-BE49-F238E27FC236}">
                  <a16:creationId xmlns:a16="http://schemas.microsoft.com/office/drawing/2014/main" id="{5A1E0F5C-1CD8-42DE-855C-785AE1404351}"/>
                </a:ext>
              </a:extLst>
            </p:cNvPr>
            <p:cNvSpPr/>
            <p:nvPr/>
          </p:nvSpPr>
          <p:spPr>
            <a:xfrm>
              <a:off x="9799419" y="4583362"/>
              <a:ext cx="206405" cy="228632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 w="19050">
              <a:solidFill>
                <a:schemeClr val="bg2">
                  <a:lumMod val="1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CaixaDeTexto 51">
              <a:extLst>
                <a:ext uri="{FF2B5EF4-FFF2-40B4-BE49-F238E27FC236}">
                  <a16:creationId xmlns:a16="http://schemas.microsoft.com/office/drawing/2014/main" id="{88499277-84D9-448B-AAF4-ADECF5F236BB}"/>
                </a:ext>
              </a:extLst>
            </p:cNvPr>
            <p:cNvSpPr txBox="1"/>
            <p:nvPr/>
          </p:nvSpPr>
          <p:spPr>
            <a:xfrm>
              <a:off x="10005824" y="4555837"/>
              <a:ext cx="2044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t applicable</a:t>
              </a:r>
              <a:endParaRPr lang="pt-BR" sz="12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135092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175C7742CF67B94693F52F21A125A5B9" ma:contentTypeVersion="9" ma:contentTypeDescription="Crie um novo documento." ma:contentTypeScope="" ma:versionID="afc06e8ea8857c19f596d7acf31c3260">
  <xsd:schema xmlns:xsd="http://www.w3.org/2001/XMLSchema" xmlns:xs="http://www.w3.org/2001/XMLSchema" xmlns:p="http://schemas.microsoft.com/office/2006/metadata/properties" xmlns:ns3="4302c49d-1ee8-4285-a759-5aa42ebc0471" targetNamespace="http://schemas.microsoft.com/office/2006/metadata/properties" ma:root="true" ma:fieldsID="edaaa1ba61a427f0780317294310f016" ns3:_="">
    <xsd:import namespace="4302c49d-1ee8-4285-a759-5aa42ebc047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302c49d-1ee8-4285-a759-5aa42ebc047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ú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E5CDD9DC-B8CC-4428-A59B-A35AB1B19518}">
  <ds:schemaRefs>
    <ds:schemaRef ds:uri="http://purl.org/dc/elements/1.1/"/>
    <ds:schemaRef ds:uri="http://schemas.microsoft.com/office/2006/documentManagement/types"/>
    <ds:schemaRef ds:uri="4302c49d-1ee8-4285-a759-5aa42ebc0471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schemas.microsoft.com/office/2006/metadata/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8034A061-1054-4EEB-8714-1B690391EE2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302c49d-1ee8-4285-a759-5aa42ebc047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3E31016A-6D52-4285-B55F-7F5286E830E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11</TotalTime>
  <Words>81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MILA OSPINA AYALA</dc:creator>
  <cp:lastModifiedBy>Rita Mattiello</cp:lastModifiedBy>
  <cp:revision>8</cp:revision>
  <dcterms:created xsi:type="dcterms:W3CDTF">2021-10-29T14:39:58Z</dcterms:created>
  <dcterms:modified xsi:type="dcterms:W3CDTF">2022-03-08T20:57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75C7742CF67B94693F52F21A125A5B9</vt:lpwstr>
  </property>
</Properties>
</file>